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4" r:id="rId4"/>
    <p:sldId id="258" r:id="rId5"/>
    <p:sldId id="259" r:id="rId6"/>
    <p:sldId id="260" r:id="rId7"/>
    <p:sldId id="263" r:id="rId8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Estilo Mé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97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uno Robbs" userId="646f45108becd9d1" providerId="LiveId" clId="{FDBBA07E-BCDC-4BD7-ACBE-E508FFFFF56C}"/>
    <pc:docChg chg="undo custSel addSld modSld">
      <pc:chgData name="Bruno Robbs" userId="646f45108becd9d1" providerId="LiveId" clId="{FDBBA07E-BCDC-4BD7-ACBE-E508FFFFF56C}" dt="2023-06-05T15:14:55.690" v="1063" actId="20577"/>
      <pc:docMkLst>
        <pc:docMk/>
      </pc:docMkLst>
      <pc:sldChg chg="addSp delSp modSp mod">
        <pc:chgData name="Bruno Robbs" userId="646f45108becd9d1" providerId="LiveId" clId="{FDBBA07E-BCDC-4BD7-ACBE-E508FFFFF56C}" dt="2023-05-31T15:25:52.902" v="1056"/>
        <pc:sldMkLst>
          <pc:docMk/>
          <pc:sldMk cId="3371538988" sldId="257"/>
        </pc:sldMkLst>
        <pc:spChg chg="add mod">
          <ac:chgData name="Bruno Robbs" userId="646f45108becd9d1" providerId="LiveId" clId="{FDBBA07E-BCDC-4BD7-ACBE-E508FFFFF56C}" dt="2023-05-24T13:44:14.393" v="297" actId="1035"/>
          <ac:spMkLst>
            <pc:docMk/>
            <pc:sldMk cId="3371538988" sldId="257"/>
            <ac:spMk id="6" creationId="{8B924057-9149-6AE7-A390-D6C9657762E2}"/>
          </ac:spMkLst>
        </pc:spChg>
        <pc:spChg chg="add mod">
          <ac:chgData name="Bruno Robbs" userId="646f45108becd9d1" providerId="LiveId" clId="{FDBBA07E-BCDC-4BD7-ACBE-E508FFFFF56C}" dt="2023-05-24T13:48:50.243" v="356" actId="1035"/>
          <ac:spMkLst>
            <pc:docMk/>
            <pc:sldMk cId="3371538988" sldId="257"/>
            <ac:spMk id="7" creationId="{F813553F-DCE2-AB96-8262-B3F4124C6FD1}"/>
          </ac:spMkLst>
        </pc:spChg>
        <pc:spChg chg="add mod">
          <ac:chgData name="Bruno Robbs" userId="646f45108becd9d1" providerId="LiveId" clId="{FDBBA07E-BCDC-4BD7-ACBE-E508FFFFF56C}" dt="2023-05-24T13:49:05.838" v="519" actId="1035"/>
          <ac:spMkLst>
            <pc:docMk/>
            <pc:sldMk cId="3371538988" sldId="257"/>
            <ac:spMk id="9" creationId="{D3E16D0A-880D-AFB1-3D61-C878C66F641C}"/>
          </ac:spMkLst>
        </pc:spChg>
        <pc:spChg chg="del">
          <ac:chgData name="Bruno Robbs" userId="646f45108becd9d1" providerId="LiveId" clId="{FDBBA07E-BCDC-4BD7-ACBE-E508FFFFF56C}" dt="2023-05-24T13:38:18.577" v="1" actId="478"/>
          <ac:spMkLst>
            <pc:docMk/>
            <pc:sldMk cId="3371538988" sldId="257"/>
            <ac:spMk id="11" creationId="{5DF48332-21FB-47A3-A834-43CDAB0EFF26}"/>
          </ac:spMkLst>
        </pc:spChg>
        <pc:spChg chg="del">
          <ac:chgData name="Bruno Robbs" userId="646f45108becd9d1" providerId="LiveId" clId="{FDBBA07E-BCDC-4BD7-ACBE-E508FFFFF56C}" dt="2023-05-24T13:38:18.577" v="1" actId="478"/>
          <ac:spMkLst>
            <pc:docMk/>
            <pc:sldMk cId="3371538988" sldId="257"/>
            <ac:spMk id="12" creationId="{7185DE1C-307E-105A-753B-7A0C0B7E9BF7}"/>
          </ac:spMkLst>
        </pc:spChg>
        <pc:spChg chg="del">
          <ac:chgData name="Bruno Robbs" userId="646f45108becd9d1" providerId="LiveId" clId="{FDBBA07E-BCDC-4BD7-ACBE-E508FFFFF56C}" dt="2023-05-24T13:38:18.577" v="1" actId="478"/>
          <ac:spMkLst>
            <pc:docMk/>
            <pc:sldMk cId="3371538988" sldId="257"/>
            <ac:spMk id="13" creationId="{4F49C7F5-7BA9-4A2C-CA24-8CD539945B93}"/>
          </ac:spMkLst>
        </pc:spChg>
        <pc:spChg chg="del">
          <ac:chgData name="Bruno Robbs" userId="646f45108becd9d1" providerId="LiveId" clId="{FDBBA07E-BCDC-4BD7-ACBE-E508FFFFF56C}" dt="2023-05-24T13:38:18.577" v="1" actId="478"/>
          <ac:spMkLst>
            <pc:docMk/>
            <pc:sldMk cId="3371538988" sldId="257"/>
            <ac:spMk id="14" creationId="{E1E01747-B0D4-C72E-0273-18897D33098D}"/>
          </ac:spMkLst>
        </pc:spChg>
        <pc:spChg chg="del">
          <ac:chgData name="Bruno Robbs" userId="646f45108becd9d1" providerId="LiveId" clId="{FDBBA07E-BCDC-4BD7-ACBE-E508FFFFF56C}" dt="2023-05-24T13:38:22.644" v="3" actId="478"/>
          <ac:spMkLst>
            <pc:docMk/>
            <pc:sldMk cId="3371538988" sldId="257"/>
            <ac:spMk id="16" creationId="{AEB51725-42EC-8864-B463-410249625033}"/>
          </ac:spMkLst>
        </pc:spChg>
        <pc:spChg chg="del">
          <ac:chgData name="Bruno Robbs" userId="646f45108becd9d1" providerId="LiveId" clId="{FDBBA07E-BCDC-4BD7-ACBE-E508FFFFF56C}" dt="2023-05-24T13:38:20.584" v="2" actId="478"/>
          <ac:spMkLst>
            <pc:docMk/>
            <pc:sldMk cId="3371538988" sldId="257"/>
            <ac:spMk id="17" creationId="{3B76036D-8FCC-D05E-5D7F-EF261E7999BD}"/>
          </ac:spMkLst>
        </pc:spChg>
        <pc:spChg chg="del">
          <ac:chgData name="Bruno Robbs" userId="646f45108becd9d1" providerId="LiveId" clId="{FDBBA07E-BCDC-4BD7-ACBE-E508FFFFF56C}" dt="2023-05-24T13:38:18.577" v="1" actId="478"/>
          <ac:spMkLst>
            <pc:docMk/>
            <pc:sldMk cId="3371538988" sldId="257"/>
            <ac:spMk id="20" creationId="{43277973-00A2-9E53-E877-CA40553B73A8}"/>
          </ac:spMkLst>
        </pc:spChg>
        <pc:spChg chg="del">
          <ac:chgData name="Bruno Robbs" userId="646f45108becd9d1" providerId="LiveId" clId="{FDBBA07E-BCDC-4BD7-ACBE-E508FFFFF56C}" dt="2023-05-24T13:38:18.577" v="1" actId="478"/>
          <ac:spMkLst>
            <pc:docMk/>
            <pc:sldMk cId="3371538988" sldId="257"/>
            <ac:spMk id="22" creationId="{B7DD0347-3744-13A8-F819-0F5122282F8B}"/>
          </ac:spMkLst>
        </pc:spChg>
        <pc:spChg chg="del">
          <ac:chgData name="Bruno Robbs" userId="646f45108becd9d1" providerId="LiveId" clId="{FDBBA07E-BCDC-4BD7-ACBE-E508FFFFF56C}" dt="2023-05-24T13:38:20.584" v="2" actId="478"/>
          <ac:spMkLst>
            <pc:docMk/>
            <pc:sldMk cId="3371538988" sldId="257"/>
            <ac:spMk id="25" creationId="{0C3AF4F0-4C54-112A-4A38-992F7AFFDB8C}"/>
          </ac:spMkLst>
        </pc:spChg>
        <pc:spChg chg="del">
          <ac:chgData name="Bruno Robbs" userId="646f45108becd9d1" providerId="LiveId" clId="{FDBBA07E-BCDC-4BD7-ACBE-E508FFFFF56C}" dt="2023-05-24T13:38:20.584" v="2" actId="478"/>
          <ac:spMkLst>
            <pc:docMk/>
            <pc:sldMk cId="3371538988" sldId="257"/>
            <ac:spMk id="26" creationId="{58CBE26B-01C2-B98B-1EAF-0EFEEED3F061}"/>
          </ac:spMkLst>
        </pc:spChg>
        <pc:spChg chg="del">
          <ac:chgData name="Bruno Robbs" userId="646f45108becd9d1" providerId="LiveId" clId="{FDBBA07E-BCDC-4BD7-ACBE-E508FFFFF56C}" dt="2023-05-24T13:38:43.714" v="6" actId="478"/>
          <ac:spMkLst>
            <pc:docMk/>
            <pc:sldMk cId="3371538988" sldId="257"/>
            <ac:spMk id="28" creationId="{2EE70A61-29FB-E32F-9A4D-AD92407ADC1D}"/>
          </ac:spMkLst>
        </pc:spChg>
        <pc:spChg chg="del">
          <ac:chgData name="Bruno Robbs" userId="646f45108becd9d1" providerId="LiveId" clId="{FDBBA07E-BCDC-4BD7-ACBE-E508FFFFF56C}" dt="2023-05-24T13:38:20.584" v="2" actId="478"/>
          <ac:spMkLst>
            <pc:docMk/>
            <pc:sldMk cId="3371538988" sldId="257"/>
            <ac:spMk id="29" creationId="{9FCF9239-B426-C417-356A-AF78060EEFE4}"/>
          </ac:spMkLst>
        </pc:spChg>
        <pc:graphicFrameChg chg="add mod">
          <ac:chgData name="Bruno Robbs" userId="646f45108becd9d1" providerId="LiveId" clId="{FDBBA07E-BCDC-4BD7-ACBE-E508FFFFF56C}" dt="2023-05-31T15:25:52.902" v="1056"/>
          <ac:graphicFrameMkLst>
            <pc:docMk/>
            <pc:sldMk cId="3371538988" sldId="257"/>
            <ac:graphicFrameMk id="3" creationId="{D5E293A7-AEE2-0FEA-0ADF-1CB17BF9FAD6}"/>
          </ac:graphicFrameMkLst>
        </pc:graphicFrameChg>
        <pc:graphicFrameChg chg="add mod">
          <ac:chgData name="Bruno Robbs" userId="646f45108becd9d1" providerId="LiveId" clId="{FDBBA07E-BCDC-4BD7-ACBE-E508FFFFF56C}" dt="2023-05-24T13:51:29.161" v="523"/>
          <ac:graphicFrameMkLst>
            <pc:docMk/>
            <pc:sldMk cId="3371538988" sldId="257"/>
            <ac:graphicFrameMk id="5" creationId="{9212E697-7076-D960-B030-B1B41CD67598}"/>
          </ac:graphicFrameMkLst>
        </pc:graphicFrameChg>
        <pc:graphicFrameChg chg="del">
          <ac:chgData name="Bruno Robbs" userId="646f45108becd9d1" providerId="LiveId" clId="{FDBBA07E-BCDC-4BD7-ACBE-E508FFFFF56C}" dt="2023-05-24T13:38:18.577" v="1" actId="478"/>
          <ac:graphicFrameMkLst>
            <pc:docMk/>
            <pc:sldMk cId="3371538988" sldId="257"/>
            <ac:graphicFrameMk id="8" creationId="{8E4A5562-6B25-12E9-AB8A-9C81B3063947}"/>
          </ac:graphicFrameMkLst>
        </pc:graphicFrameChg>
        <pc:picChg chg="del">
          <ac:chgData name="Bruno Robbs" userId="646f45108becd9d1" providerId="LiveId" clId="{FDBBA07E-BCDC-4BD7-ACBE-E508FFFFF56C}" dt="2023-05-24T13:38:18.577" v="1" actId="478"/>
          <ac:picMkLst>
            <pc:docMk/>
            <pc:sldMk cId="3371538988" sldId="257"/>
            <ac:picMk id="4" creationId="{FAFFF390-E7F6-FEF1-49E1-57AEE77BC880}"/>
          </ac:picMkLst>
        </pc:picChg>
        <pc:picChg chg="del">
          <ac:chgData name="Bruno Robbs" userId="646f45108becd9d1" providerId="LiveId" clId="{FDBBA07E-BCDC-4BD7-ACBE-E508FFFFF56C}" dt="2023-05-24T13:38:18.577" v="1" actId="478"/>
          <ac:picMkLst>
            <pc:docMk/>
            <pc:sldMk cId="3371538988" sldId="257"/>
            <ac:picMk id="23" creationId="{15072767-D506-D8D2-4381-413D440BDDEC}"/>
          </ac:picMkLst>
        </pc:picChg>
        <pc:picChg chg="del">
          <ac:chgData name="Bruno Robbs" userId="646f45108becd9d1" providerId="LiveId" clId="{FDBBA07E-BCDC-4BD7-ACBE-E508FFFFF56C}" dt="2023-05-24T13:38:18.577" v="1" actId="478"/>
          <ac:picMkLst>
            <pc:docMk/>
            <pc:sldMk cId="3371538988" sldId="257"/>
            <ac:picMk id="24" creationId="{3D9DA66A-D640-A1E4-7A60-4AB626E0F1C8}"/>
          </ac:picMkLst>
        </pc:picChg>
      </pc:sldChg>
      <pc:sldChg chg="modSp mod">
        <pc:chgData name="Bruno Robbs" userId="646f45108becd9d1" providerId="LiveId" clId="{FDBBA07E-BCDC-4BD7-ACBE-E508FFFFF56C}" dt="2023-06-05T15:14:55.690" v="1063" actId="20577"/>
        <pc:sldMkLst>
          <pc:docMk/>
          <pc:sldMk cId="3590562119" sldId="258"/>
        </pc:sldMkLst>
        <pc:graphicFrameChg chg="modGraphic">
          <ac:chgData name="Bruno Robbs" userId="646f45108becd9d1" providerId="LiveId" clId="{FDBBA07E-BCDC-4BD7-ACBE-E508FFFFF56C}" dt="2023-06-05T15:14:55.690" v="1063" actId="20577"/>
          <ac:graphicFrameMkLst>
            <pc:docMk/>
            <pc:sldMk cId="3590562119" sldId="258"/>
            <ac:graphicFrameMk id="6" creationId="{7E3D9EB9-540E-AB6C-34F0-E6A76B385655}"/>
          </ac:graphicFrameMkLst>
        </pc:graphicFrameChg>
      </pc:sldChg>
      <pc:sldChg chg="modSp mod">
        <pc:chgData name="Bruno Robbs" userId="646f45108becd9d1" providerId="LiveId" clId="{FDBBA07E-BCDC-4BD7-ACBE-E508FFFFF56C}" dt="2023-06-05T11:48:15.423" v="1058" actId="14734"/>
        <pc:sldMkLst>
          <pc:docMk/>
          <pc:sldMk cId="2921506580" sldId="259"/>
        </pc:sldMkLst>
        <pc:graphicFrameChg chg="modGraphic">
          <ac:chgData name="Bruno Robbs" userId="646f45108becd9d1" providerId="LiveId" clId="{FDBBA07E-BCDC-4BD7-ACBE-E508FFFFF56C}" dt="2023-06-05T11:48:15.423" v="1058" actId="14734"/>
          <ac:graphicFrameMkLst>
            <pc:docMk/>
            <pc:sldMk cId="2921506580" sldId="259"/>
            <ac:graphicFrameMk id="7" creationId="{ACF30C1B-00FD-58AF-313E-4513B5C154B5}"/>
          </ac:graphicFrameMkLst>
        </pc:graphicFrameChg>
      </pc:sldChg>
      <pc:sldChg chg="addSp delSp modSp add mod">
        <pc:chgData name="Bruno Robbs" userId="646f45108becd9d1" providerId="LiveId" clId="{FDBBA07E-BCDC-4BD7-ACBE-E508FFFFF56C}" dt="2023-05-24T15:23:32.214" v="1054" actId="790"/>
        <pc:sldMkLst>
          <pc:docMk/>
          <pc:sldMk cId="795036254" sldId="264"/>
        </pc:sldMkLst>
        <pc:spChg chg="mod">
          <ac:chgData name="Bruno Robbs" userId="646f45108becd9d1" providerId="LiveId" clId="{FDBBA07E-BCDC-4BD7-ACBE-E508FFFFF56C}" dt="2023-05-24T14:04:03.691" v="653" actId="20577"/>
          <ac:spMkLst>
            <pc:docMk/>
            <pc:sldMk cId="795036254" sldId="264"/>
            <ac:spMk id="2" creationId="{F05C0C2E-81FF-CA0B-E2B7-AB7E2F8C2321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11" creationId="{5DF48332-21FB-47A3-A834-43CDAB0EFF26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12" creationId="{7185DE1C-307E-105A-753B-7A0C0B7E9BF7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13" creationId="{4F49C7F5-7BA9-4A2C-CA24-8CD539945B93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14" creationId="{E1E01747-B0D4-C72E-0273-18897D33098D}"/>
          </ac:spMkLst>
        </pc:spChg>
        <pc:spChg chg="add mod">
          <ac:chgData name="Bruno Robbs" userId="646f45108becd9d1" providerId="LiveId" clId="{FDBBA07E-BCDC-4BD7-ACBE-E508FFFFF56C}" dt="2023-05-24T14:05:26.880" v="871" actId="164"/>
          <ac:spMkLst>
            <pc:docMk/>
            <pc:sldMk cId="795036254" sldId="264"/>
            <ac:spMk id="15" creationId="{F9BFBA75-1EF7-D960-7A35-8DD4C51FC735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16" creationId="{AEB51725-42EC-8864-B463-410249625033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17" creationId="{3B76036D-8FCC-D05E-5D7F-EF261E7999BD}"/>
          </ac:spMkLst>
        </pc:spChg>
        <pc:spChg chg="add mod">
          <ac:chgData name="Bruno Robbs" userId="646f45108becd9d1" providerId="LiveId" clId="{FDBBA07E-BCDC-4BD7-ACBE-E508FFFFF56C}" dt="2023-05-24T14:05:26.880" v="871" actId="164"/>
          <ac:spMkLst>
            <pc:docMk/>
            <pc:sldMk cId="795036254" sldId="264"/>
            <ac:spMk id="18" creationId="{7AE63893-2622-6C13-21FE-ED8C9DFEFD4E}"/>
          </ac:spMkLst>
        </pc:spChg>
        <pc:spChg chg="add mod">
          <ac:chgData name="Bruno Robbs" userId="646f45108becd9d1" providerId="LiveId" clId="{FDBBA07E-BCDC-4BD7-ACBE-E508FFFFF56C}" dt="2023-05-24T14:05:26.880" v="871" actId="164"/>
          <ac:spMkLst>
            <pc:docMk/>
            <pc:sldMk cId="795036254" sldId="264"/>
            <ac:spMk id="19" creationId="{758C8748-10AA-99C7-74A2-80CA7AF39CF6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20" creationId="{43277973-00A2-9E53-E877-CA40553B73A8}"/>
          </ac:spMkLst>
        </pc:spChg>
        <pc:spChg chg="del">
          <ac:chgData name="Bruno Robbs" userId="646f45108becd9d1" providerId="LiveId" clId="{FDBBA07E-BCDC-4BD7-ACBE-E508FFFFF56C}" dt="2023-05-24T14:03:36.189" v="574" actId="478"/>
          <ac:spMkLst>
            <pc:docMk/>
            <pc:sldMk cId="795036254" sldId="264"/>
            <ac:spMk id="22" creationId="{B7DD0347-3744-13A8-F819-0F5122282F8B}"/>
          </ac:spMkLst>
        </pc:spChg>
        <pc:spChg chg="mod">
          <ac:chgData name="Bruno Robbs" userId="646f45108becd9d1" providerId="LiveId" clId="{FDBBA07E-BCDC-4BD7-ACBE-E508FFFFF56C}" dt="2023-05-24T14:13:42.525" v="1053" actId="1036"/>
          <ac:spMkLst>
            <pc:docMk/>
            <pc:sldMk cId="795036254" sldId="264"/>
            <ac:spMk id="25" creationId="{0C3AF4F0-4C54-112A-4A38-992F7AFFDB8C}"/>
          </ac:spMkLst>
        </pc:spChg>
        <pc:spChg chg="mod">
          <ac:chgData name="Bruno Robbs" userId="646f45108becd9d1" providerId="LiveId" clId="{FDBBA07E-BCDC-4BD7-ACBE-E508FFFFF56C}" dt="2023-05-24T15:23:32.214" v="1054" actId="790"/>
          <ac:spMkLst>
            <pc:docMk/>
            <pc:sldMk cId="795036254" sldId="264"/>
            <ac:spMk id="26" creationId="{58CBE26B-01C2-B98B-1EAF-0EFEEED3F061}"/>
          </ac:spMkLst>
        </pc:spChg>
        <pc:spChg chg="mod">
          <ac:chgData name="Bruno Robbs" userId="646f45108becd9d1" providerId="LiveId" clId="{FDBBA07E-BCDC-4BD7-ACBE-E508FFFFF56C}" dt="2023-05-24T14:05:26.880" v="871" actId="164"/>
          <ac:spMkLst>
            <pc:docMk/>
            <pc:sldMk cId="795036254" sldId="264"/>
            <ac:spMk id="27" creationId="{91443587-322E-63D5-D030-857F3F3203AA}"/>
          </ac:spMkLst>
        </pc:spChg>
        <pc:spChg chg="del mod">
          <ac:chgData name="Bruno Robbs" userId="646f45108becd9d1" providerId="LiveId" clId="{FDBBA07E-BCDC-4BD7-ACBE-E508FFFFF56C}" dt="2023-05-24T14:13:06.556" v="971" actId="478"/>
          <ac:spMkLst>
            <pc:docMk/>
            <pc:sldMk cId="795036254" sldId="264"/>
            <ac:spMk id="28" creationId="{2EE70A61-29FB-E32F-9A4D-AD92407ADC1D}"/>
          </ac:spMkLst>
        </pc:spChg>
        <pc:spChg chg="del mod">
          <ac:chgData name="Bruno Robbs" userId="646f45108becd9d1" providerId="LiveId" clId="{FDBBA07E-BCDC-4BD7-ACBE-E508FFFFF56C}" dt="2023-05-24T14:03:41.093" v="575" actId="478"/>
          <ac:spMkLst>
            <pc:docMk/>
            <pc:sldMk cId="795036254" sldId="264"/>
            <ac:spMk id="29" creationId="{9FCF9239-B426-C417-356A-AF78060EEFE4}"/>
          </ac:spMkLst>
        </pc:spChg>
        <pc:grpChg chg="add mod">
          <ac:chgData name="Bruno Robbs" userId="646f45108becd9d1" providerId="LiveId" clId="{FDBBA07E-BCDC-4BD7-ACBE-E508FFFFF56C}" dt="2023-05-24T14:05:26.880" v="871" actId="164"/>
          <ac:grpSpMkLst>
            <pc:docMk/>
            <pc:sldMk cId="795036254" sldId="264"/>
            <ac:grpSpMk id="21" creationId="{B1DCB615-4A18-5ACA-F15F-6F9587D9141D}"/>
          </ac:grpSpMkLst>
        </pc:grpChg>
        <pc:graphicFrameChg chg="del mod">
          <ac:chgData name="Bruno Robbs" userId="646f45108becd9d1" providerId="LiveId" clId="{FDBBA07E-BCDC-4BD7-ACBE-E508FFFFF56C}" dt="2023-05-24T14:11:12.003" v="951" actId="478"/>
          <ac:graphicFrameMkLst>
            <pc:docMk/>
            <pc:sldMk cId="795036254" sldId="264"/>
            <ac:graphicFrameMk id="8" creationId="{8E4A5562-6B25-12E9-AB8A-9C81B3063947}"/>
          </ac:graphicFrameMkLst>
        </pc:graphicFrameChg>
        <pc:graphicFrameChg chg="add del mod">
          <ac:chgData name="Bruno Robbs" userId="646f45108becd9d1" providerId="LiveId" clId="{FDBBA07E-BCDC-4BD7-ACBE-E508FFFFF56C}" dt="2023-05-24T14:13:06.556" v="971" actId="478"/>
          <ac:graphicFrameMkLst>
            <pc:docMk/>
            <pc:sldMk cId="795036254" sldId="264"/>
            <ac:graphicFrameMk id="30" creationId="{D6D534FF-CF92-0D76-E913-5BD2834011BF}"/>
          </ac:graphicFrameMkLst>
        </pc:graphicFrameChg>
        <pc:picChg chg="add mod">
          <ac:chgData name="Bruno Robbs" userId="646f45108becd9d1" providerId="LiveId" clId="{FDBBA07E-BCDC-4BD7-ACBE-E508FFFFF56C}" dt="2023-05-24T14:05:26.880" v="871" actId="164"/>
          <ac:picMkLst>
            <pc:docMk/>
            <pc:sldMk cId="795036254" sldId="264"/>
            <ac:picMk id="3" creationId="{47B64E81-444B-C140-2008-01D736972803}"/>
          </ac:picMkLst>
        </pc:picChg>
        <pc:picChg chg="del">
          <ac:chgData name="Bruno Robbs" userId="646f45108becd9d1" providerId="LiveId" clId="{FDBBA07E-BCDC-4BD7-ACBE-E508FFFFF56C}" dt="2023-05-24T14:02:46.577" v="524" actId="478"/>
          <ac:picMkLst>
            <pc:docMk/>
            <pc:sldMk cId="795036254" sldId="264"/>
            <ac:picMk id="4" creationId="{FAFFF390-E7F6-FEF1-49E1-57AEE77BC880}"/>
          </ac:picMkLst>
        </pc:picChg>
        <pc:picChg chg="add mod">
          <ac:chgData name="Bruno Robbs" userId="646f45108becd9d1" providerId="LiveId" clId="{FDBBA07E-BCDC-4BD7-ACBE-E508FFFFF56C}" dt="2023-05-24T14:05:26.880" v="871" actId="164"/>
          <ac:picMkLst>
            <pc:docMk/>
            <pc:sldMk cId="795036254" sldId="264"/>
            <ac:picMk id="5" creationId="{7BD343D3-9787-8668-8EF0-78C959A2DF5C}"/>
          </ac:picMkLst>
        </pc:picChg>
        <pc:picChg chg="add mod">
          <ac:chgData name="Bruno Robbs" userId="646f45108becd9d1" providerId="LiveId" clId="{FDBBA07E-BCDC-4BD7-ACBE-E508FFFFF56C}" dt="2023-05-24T14:05:26.880" v="871" actId="164"/>
          <ac:picMkLst>
            <pc:docMk/>
            <pc:sldMk cId="795036254" sldId="264"/>
            <ac:picMk id="6" creationId="{3AC8F741-06D8-FD7B-9E03-C201D0F7DFDC}"/>
          </ac:picMkLst>
        </pc:picChg>
        <pc:picChg chg="add mod">
          <ac:chgData name="Bruno Robbs" userId="646f45108becd9d1" providerId="LiveId" clId="{FDBBA07E-BCDC-4BD7-ACBE-E508FFFFF56C}" dt="2023-05-24T14:05:26.880" v="871" actId="164"/>
          <ac:picMkLst>
            <pc:docMk/>
            <pc:sldMk cId="795036254" sldId="264"/>
            <ac:picMk id="7" creationId="{7569DAFA-53A9-7E6C-682A-18DA07F46B6E}"/>
          </ac:picMkLst>
        </pc:picChg>
        <pc:picChg chg="add mod">
          <ac:chgData name="Bruno Robbs" userId="646f45108becd9d1" providerId="LiveId" clId="{FDBBA07E-BCDC-4BD7-ACBE-E508FFFFF56C}" dt="2023-05-24T14:05:26.880" v="871" actId="164"/>
          <ac:picMkLst>
            <pc:docMk/>
            <pc:sldMk cId="795036254" sldId="264"/>
            <ac:picMk id="9" creationId="{196931AD-3E14-9EEF-47F2-8F6F1645ACD8}"/>
          </ac:picMkLst>
        </pc:picChg>
        <pc:picChg chg="add mod">
          <ac:chgData name="Bruno Robbs" userId="646f45108becd9d1" providerId="LiveId" clId="{FDBBA07E-BCDC-4BD7-ACBE-E508FFFFF56C}" dt="2023-05-24T14:05:26.880" v="871" actId="164"/>
          <ac:picMkLst>
            <pc:docMk/>
            <pc:sldMk cId="795036254" sldId="264"/>
            <ac:picMk id="10" creationId="{88AD3799-9F1B-1D13-97CB-07482B60DA5C}"/>
          </ac:picMkLst>
        </pc:picChg>
        <pc:picChg chg="del">
          <ac:chgData name="Bruno Robbs" userId="646f45108becd9d1" providerId="LiveId" clId="{FDBBA07E-BCDC-4BD7-ACBE-E508FFFFF56C}" dt="2023-05-24T14:03:36.189" v="574" actId="478"/>
          <ac:picMkLst>
            <pc:docMk/>
            <pc:sldMk cId="795036254" sldId="264"/>
            <ac:picMk id="23" creationId="{15072767-D506-D8D2-4381-413D440BDDEC}"/>
          </ac:picMkLst>
        </pc:picChg>
        <pc:picChg chg="del">
          <ac:chgData name="Bruno Robbs" userId="646f45108becd9d1" providerId="LiveId" clId="{FDBBA07E-BCDC-4BD7-ACBE-E508FFFFF56C}" dt="2023-05-24T14:03:36.189" v="574" actId="478"/>
          <ac:picMkLst>
            <pc:docMk/>
            <pc:sldMk cId="795036254" sldId="264"/>
            <ac:picMk id="24" creationId="{3D9DA66A-D640-A1E4-7A60-4AB626E0F1C8}"/>
          </ac:picMkLst>
        </pc:picChg>
      </pc:sldChg>
    </pc:docChg>
  </pc:docChgLst>
  <pc:docChgLst>
    <pc:chgData name="Bruno Robbs" userId="646f45108becd9d1" providerId="LiveId" clId="{55CE49E9-B140-46C5-8100-8F7654C1C65B}"/>
    <pc:docChg chg="undo redo custSel addSld delSld modSld">
      <pc:chgData name="Bruno Robbs" userId="646f45108becd9d1" providerId="LiveId" clId="{55CE49E9-B140-46C5-8100-8F7654C1C65B}" dt="2022-09-05T19:50:57.571" v="250" actId="6549"/>
      <pc:docMkLst>
        <pc:docMk/>
      </pc:docMkLst>
      <pc:sldChg chg="modSp mod">
        <pc:chgData name="Bruno Robbs" userId="646f45108becd9d1" providerId="LiveId" clId="{55CE49E9-B140-46C5-8100-8F7654C1C65B}" dt="2022-08-31T16:57:43.890" v="4" actId="1037"/>
        <pc:sldMkLst>
          <pc:docMk/>
          <pc:sldMk cId="354287945" sldId="256"/>
        </pc:sldMkLst>
        <pc:spChg chg="mod">
          <ac:chgData name="Bruno Robbs" userId="646f45108becd9d1" providerId="LiveId" clId="{55CE49E9-B140-46C5-8100-8F7654C1C65B}" dt="2022-08-31T16:57:43.890" v="4" actId="1037"/>
          <ac:spMkLst>
            <pc:docMk/>
            <pc:sldMk cId="354287945" sldId="256"/>
            <ac:spMk id="55" creationId="{6F7C1241-0D14-4253-939C-C13A9584C905}"/>
          </ac:spMkLst>
        </pc:spChg>
      </pc:sldChg>
      <pc:sldChg chg="modSp mod">
        <pc:chgData name="Bruno Robbs" userId="646f45108becd9d1" providerId="LiveId" clId="{55CE49E9-B140-46C5-8100-8F7654C1C65B}" dt="2022-09-01T15:19:25.530" v="78"/>
        <pc:sldMkLst>
          <pc:docMk/>
          <pc:sldMk cId="3371538988" sldId="257"/>
        </pc:sldMkLst>
        <pc:spChg chg="mod">
          <ac:chgData name="Bruno Robbs" userId="646f45108becd9d1" providerId="LiveId" clId="{55CE49E9-B140-46C5-8100-8F7654C1C65B}" dt="2022-09-01T15:18:54.035" v="73" actId="20577"/>
          <ac:spMkLst>
            <pc:docMk/>
            <pc:sldMk cId="3371538988" sldId="257"/>
            <ac:spMk id="25" creationId="{0C3AF4F0-4C54-112A-4A38-992F7AFFDB8C}"/>
          </ac:spMkLst>
        </pc:spChg>
        <pc:spChg chg="mod">
          <ac:chgData name="Bruno Robbs" userId="646f45108becd9d1" providerId="LiveId" clId="{55CE49E9-B140-46C5-8100-8F7654C1C65B}" dt="2022-09-01T15:18:58.959" v="76" actId="20577"/>
          <ac:spMkLst>
            <pc:docMk/>
            <pc:sldMk cId="3371538988" sldId="257"/>
            <ac:spMk id="26" creationId="{58CBE26B-01C2-B98B-1EAF-0EFEEED3F061}"/>
          </ac:spMkLst>
        </pc:spChg>
        <pc:graphicFrameChg chg="mod">
          <ac:chgData name="Bruno Robbs" userId="646f45108becd9d1" providerId="LiveId" clId="{55CE49E9-B140-46C5-8100-8F7654C1C65B}" dt="2022-09-01T15:19:25.530" v="78"/>
          <ac:graphicFrameMkLst>
            <pc:docMk/>
            <pc:sldMk cId="3371538988" sldId="257"/>
            <ac:graphicFrameMk id="8" creationId="{8E4A5562-6B25-12E9-AB8A-9C81B3063947}"/>
          </ac:graphicFrameMkLst>
        </pc:graphicFrameChg>
      </pc:sldChg>
      <pc:sldChg chg="addSp delSp modSp new add del mod">
        <pc:chgData name="Bruno Robbs" userId="646f45108becd9d1" providerId="LiveId" clId="{55CE49E9-B140-46C5-8100-8F7654C1C65B}" dt="2022-09-02T17:02:49.911" v="144"/>
        <pc:sldMkLst>
          <pc:docMk/>
          <pc:sldMk cId="3590562119" sldId="258"/>
        </pc:sldMkLst>
        <pc:spChg chg="del">
          <ac:chgData name="Bruno Robbs" userId="646f45108becd9d1" providerId="LiveId" clId="{55CE49E9-B140-46C5-8100-8F7654C1C65B}" dt="2022-09-01T13:12:16.702" v="6" actId="478"/>
          <ac:spMkLst>
            <pc:docMk/>
            <pc:sldMk cId="3590562119" sldId="258"/>
            <ac:spMk id="2" creationId="{104428FD-B500-BBBE-18F3-E55E1A819461}"/>
          </ac:spMkLst>
        </pc:spChg>
        <pc:spChg chg="del">
          <ac:chgData name="Bruno Robbs" userId="646f45108becd9d1" providerId="LiveId" clId="{55CE49E9-B140-46C5-8100-8F7654C1C65B}" dt="2022-09-01T13:12:16.702" v="6" actId="478"/>
          <ac:spMkLst>
            <pc:docMk/>
            <pc:sldMk cId="3590562119" sldId="258"/>
            <ac:spMk id="3" creationId="{1BC42233-C2C0-3F81-7387-03B4B4BA8B76}"/>
          </ac:spMkLst>
        </pc:spChg>
        <pc:graphicFrameChg chg="add del mod modGraphic">
          <ac:chgData name="Bruno Robbs" userId="646f45108becd9d1" providerId="LiveId" clId="{55CE49E9-B140-46C5-8100-8F7654C1C65B}" dt="2022-09-01T13:46:52.277" v="14"/>
          <ac:graphicFrameMkLst>
            <pc:docMk/>
            <pc:sldMk cId="3590562119" sldId="258"/>
            <ac:graphicFrameMk id="4" creationId="{E21C0DDB-807F-13EB-00E3-A89C067DE508}"/>
          </ac:graphicFrameMkLst>
        </pc:graphicFrameChg>
        <pc:graphicFrameChg chg="add del mod modGraphic">
          <ac:chgData name="Bruno Robbs" userId="646f45108becd9d1" providerId="LiveId" clId="{55CE49E9-B140-46C5-8100-8F7654C1C65B}" dt="2022-09-02T16:58:02.852" v="79" actId="478"/>
          <ac:graphicFrameMkLst>
            <pc:docMk/>
            <pc:sldMk cId="3590562119" sldId="258"/>
            <ac:graphicFrameMk id="5" creationId="{46FEC854-3621-86A4-A78B-F9FF3712757E}"/>
          </ac:graphicFrameMkLst>
        </pc:graphicFrameChg>
        <pc:graphicFrameChg chg="add mod modGraphic">
          <ac:chgData name="Bruno Robbs" userId="646f45108becd9d1" providerId="LiveId" clId="{55CE49E9-B140-46C5-8100-8F7654C1C65B}" dt="2022-09-02T17:02:49.911" v="144"/>
          <ac:graphicFrameMkLst>
            <pc:docMk/>
            <pc:sldMk cId="3590562119" sldId="258"/>
            <ac:graphicFrameMk id="6" creationId="{7E3D9EB9-540E-AB6C-34F0-E6A76B385655}"/>
          </ac:graphicFrameMkLst>
        </pc:graphicFrameChg>
      </pc:sldChg>
      <pc:sldChg chg="addSp delSp modSp new add del mod">
        <pc:chgData name="Bruno Robbs" userId="646f45108becd9d1" providerId="LiveId" clId="{55CE49E9-B140-46C5-8100-8F7654C1C65B}" dt="2022-09-02T17:02:57.062" v="145" actId="12385"/>
        <pc:sldMkLst>
          <pc:docMk/>
          <pc:sldMk cId="2921506580" sldId="259"/>
        </pc:sldMkLst>
        <pc:spChg chg="del">
          <ac:chgData name="Bruno Robbs" userId="646f45108becd9d1" providerId="LiveId" clId="{55CE49E9-B140-46C5-8100-8F7654C1C65B}" dt="2022-09-01T13:52:23.741" v="27" actId="478"/>
          <ac:spMkLst>
            <pc:docMk/>
            <pc:sldMk cId="2921506580" sldId="259"/>
            <ac:spMk id="2" creationId="{3E29327E-56F7-45C2-5938-5E82D6981A7E}"/>
          </ac:spMkLst>
        </pc:spChg>
        <pc:spChg chg="del">
          <ac:chgData name="Bruno Robbs" userId="646f45108becd9d1" providerId="LiveId" clId="{55CE49E9-B140-46C5-8100-8F7654C1C65B}" dt="2022-09-01T13:52:15.612" v="26"/>
          <ac:spMkLst>
            <pc:docMk/>
            <pc:sldMk cId="2921506580" sldId="259"/>
            <ac:spMk id="3" creationId="{59B612DE-972A-E57D-DC6F-2859BA730E25}"/>
          </ac:spMkLst>
        </pc:spChg>
        <pc:spChg chg="add del mod">
          <ac:chgData name="Bruno Robbs" userId="646f45108becd9d1" providerId="LiveId" clId="{55CE49E9-B140-46C5-8100-8F7654C1C65B}" dt="2022-09-02T16:59:43.480" v="97" actId="478"/>
          <ac:spMkLst>
            <pc:docMk/>
            <pc:sldMk cId="2921506580" sldId="259"/>
            <ac:spMk id="6" creationId="{A0C6991B-2BE9-F4F9-44AB-864E049A3868}"/>
          </ac:spMkLst>
        </pc:spChg>
        <pc:graphicFrameChg chg="add del mod modGraphic">
          <ac:chgData name="Bruno Robbs" userId="646f45108becd9d1" providerId="LiveId" clId="{55CE49E9-B140-46C5-8100-8F7654C1C65B}" dt="2022-09-02T16:58:07.715" v="80" actId="478"/>
          <ac:graphicFrameMkLst>
            <pc:docMk/>
            <pc:sldMk cId="2921506580" sldId="259"/>
            <ac:graphicFrameMk id="4" creationId="{9B421C21-7F2A-2875-FAA2-263739CC830C}"/>
          </ac:graphicFrameMkLst>
        </pc:graphicFrameChg>
        <pc:graphicFrameChg chg="add mod modGraphic">
          <ac:chgData name="Bruno Robbs" userId="646f45108becd9d1" providerId="LiveId" clId="{55CE49E9-B140-46C5-8100-8F7654C1C65B}" dt="2022-09-02T17:02:57.062" v="145" actId="12385"/>
          <ac:graphicFrameMkLst>
            <pc:docMk/>
            <pc:sldMk cId="2921506580" sldId="259"/>
            <ac:graphicFrameMk id="7" creationId="{ACF30C1B-00FD-58AF-313E-4513B5C154B5}"/>
          </ac:graphicFrameMkLst>
        </pc:graphicFrameChg>
      </pc:sldChg>
      <pc:sldChg chg="addSp delSp modSp new add del mod">
        <pc:chgData name="Bruno Robbs" userId="646f45108becd9d1" providerId="LiveId" clId="{55CE49E9-B140-46C5-8100-8F7654C1C65B}" dt="2022-09-01T14:16:01.920" v="60" actId="47"/>
        <pc:sldMkLst>
          <pc:docMk/>
          <pc:sldMk cId="3755963801" sldId="260"/>
        </pc:sldMkLst>
        <pc:spChg chg="del">
          <ac:chgData name="Bruno Robbs" userId="646f45108becd9d1" providerId="LiveId" clId="{55CE49E9-B140-46C5-8100-8F7654C1C65B}" dt="2022-09-01T13:53:16.720" v="36" actId="478"/>
          <ac:spMkLst>
            <pc:docMk/>
            <pc:sldMk cId="3755963801" sldId="260"/>
            <ac:spMk id="2" creationId="{02EF344D-C1E6-4371-319C-090F2C312347}"/>
          </ac:spMkLst>
        </pc:spChg>
        <pc:spChg chg="del">
          <ac:chgData name="Bruno Robbs" userId="646f45108becd9d1" providerId="LiveId" clId="{55CE49E9-B140-46C5-8100-8F7654C1C65B}" dt="2022-09-01T13:53:16.720" v="36" actId="478"/>
          <ac:spMkLst>
            <pc:docMk/>
            <pc:sldMk cId="3755963801" sldId="260"/>
            <ac:spMk id="3" creationId="{FC9EC5EB-C3CB-C5A7-5F73-A5F1ACC6DFDE}"/>
          </ac:spMkLst>
        </pc:spChg>
        <pc:graphicFrameChg chg="add mod modGraphic">
          <ac:chgData name="Bruno Robbs" userId="646f45108becd9d1" providerId="LiveId" clId="{55CE49E9-B140-46C5-8100-8F7654C1C65B}" dt="2022-09-01T13:54:39.113" v="47" actId="403"/>
          <ac:graphicFrameMkLst>
            <pc:docMk/>
            <pc:sldMk cId="3755963801" sldId="260"/>
            <ac:graphicFrameMk id="4" creationId="{F58BAB07-0E30-02E7-C190-1FE7A26AEA0F}"/>
          </ac:graphicFrameMkLst>
        </pc:graphicFrameChg>
      </pc:sldChg>
      <pc:sldChg chg="addSp delSp new del mod">
        <pc:chgData name="Bruno Robbs" userId="646f45108becd9d1" providerId="LiveId" clId="{55CE49E9-B140-46C5-8100-8F7654C1C65B}" dt="2022-09-05T19:44:53.336" v="146" actId="47"/>
        <pc:sldMkLst>
          <pc:docMk/>
          <pc:sldMk cId="3608359641" sldId="261"/>
        </pc:sldMkLst>
        <pc:spChg chg="add del">
          <ac:chgData name="Bruno Robbs" userId="646f45108becd9d1" providerId="LiveId" clId="{55CE49E9-B140-46C5-8100-8F7654C1C65B}" dt="2022-09-01T14:16:12.972" v="71" actId="478"/>
          <ac:spMkLst>
            <pc:docMk/>
            <pc:sldMk cId="3608359641" sldId="261"/>
            <ac:spMk id="2" creationId="{51EBFBF7-6038-5486-7119-E02B0287D8C1}"/>
          </ac:spMkLst>
        </pc:spChg>
        <pc:spChg chg="add del">
          <ac:chgData name="Bruno Robbs" userId="646f45108becd9d1" providerId="LiveId" clId="{55CE49E9-B140-46C5-8100-8F7654C1C65B}" dt="2022-09-01T14:16:12.972" v="71" actId="478"/>
          <ac:spMkLst>
            <pc:docMk/>
            <pc:sldMk cId="3608359641" sldId="261"/>
            <ac:spMk id="3" creationId="{34B56E08-2127-AC4B-EF72-2B94295186CB}"/>
          </ac:spMkLst>
        </pc:spChg>
      </pc:sldChg>
      <pc:sldChg chg="addSp delSp modSp add mod">
        <pc:chgData name="Bruno Robbs" userId="646f45108becd9d1" providerId="LiveId" clId="{55CE49E9-B140-46C5-8100-8F7654C1C65B}" dt="2022-09-05T19:50:57.571" v="250" actId="6549"/>
        <pc:sldMkLst>
          <pc:docMk/>
          <pc:sldMk cId="4064671703" sldId="263"/>
        </pc:sldMkLst>
        <pc:spChg chg="mod">
          <ac:chgData name="Bruno Robbs" userId="646f45108becd9d1" providerId="LiveId" clId="{55CE49E9-B140-46C5-8100-8F7654C1C65B}" dt="2022-09-05T19:50:57.571" v="250" actId="6549"/>
          <ac:spMkLst>
            <pc:docMk/>
            <pc:sldMk cId="4064671703" sldId="263"/>
            <ac:spMk id="3" creationId="{E4D9FF51-A186-90C1-4352-04B45649D663}"/>
          </ac:spMkLst>
        </pc:spChg>
        <pc:spChg chg="add del">
          <ac:chgData name="Bruno Robbs" userId="646f45108becd9d1" providerId="LiveId" clId="{55CE49E9-B140-46C5-8100-8F7654C1C65B}" dt="2022-09-05T19:49:02.892" v="151"/>
          <ac:spMkLst>
            <pc:docMk/>
            <pc:sldMk cId="4064671703" sldId="263"/>
            <ac:spMk id="4" creationId="{DDD033C5-5083-DA76-1723-1214587F1459}"/>
          </ac:spMkLst>
        </pc:spChg>
      </pc:sldChg>
    </pc:docChg>
  </pc:docChgLst>
  <pc:docChgLst>
    <pc:chgData name="Bruno Robbs" userId="646f45108becd9d1" providerId="LiveId" clId="{D2A6503E-83DC-43FA-A521-CDEDBA96AF6D}"/>
    <pc:docChg chg="custSel addSld delSld modSld">
      <pc:chgData name="Bruno Robbs" userId="646f45108becd9d1" providerId="LiveId" clId="{D2A6503E-83DC-43FA-A521-CDEDBA96AF6D}" dt="2022-07-20T15:12:34.007" v="793" actId="1037"/>
      <pc:docMkLst>
        <pc:docMk/>
      </pc:docMkLst>
      <pc:sldChg chg="addSp delSp modSp new mod">
        <pc:chgData name="Bruno Robbs" userId="646f45108becd9d1" providerId="LiveId" clId="{D2A6503E-83DC-43FA-A521-CDEDBA96AF6D}" dt="2022-07-20T15:12:34.007" v="793" actId="1037"/>
        <pc:sldMkLst>
          <pc:docMk/>
          <pc:sldMk cId="3371538988" sldId="257"/>
        </pc:sldMkLst>
        <pc:spChg chg="del mod">
          <ac:chgData name="Bruno Robbs" userId="646f45108becd9d1" providerId="LiveId" clId="{D2A6503E-83DC-43FA-A521-CDEDBA96AF6D}" dt="2022-07-20T15:02:03.241" v="2" actId="478"/>
          <ac:spMkLst>
            <pc:docMk/>
            <pc:sldMk cId="3371538988" sldId="257"/>
            <ac:spMk id="2" creationId="{DC01767B-8C7F-251B-787B-FB8809C65626}"/>
          </ac:spMkLst>
        </pc:spChg>
        <pc:spChg chg="del mod">
          <ac:chgData name="Bruno Robbs" userId="646f45108becd9d1" providerId="LiveId" clId="{D2A6503E-83DC-43FA-A521-CDEDBA96AF6D}" dt="2022-07-20T15:02:03.241" v="2" actId="478"/>
          <ac:spMkLst>
            <pc:docMk/>
            <pc:sldMk cId="3371538988" sldId="257"/>
            <ac:spMk id="3" creationId="{BD35732D-01EE-7596-9029-EE9A9ABB3EE9}"/>
          </ac:spMkLst>
        </pc:spChg>
        <pc:spChg chg="del mod topLvl">
          <ac:chgData name="Bruno Robbs" userId="646f45108becd9d1" providerId="LiveId" clId="{D2A6503E-83DC-43FA-A521-CDEDBA96AF6D}" dt="2022-07-20T15:02:52.088" v="14" actId="478"/>
          <ac:spMkLst>
            <pc:docMk/>
            <pc:sldMk cId="3371538988" sldId="257"/>
            <ac:spMk id="7" creationId="{8CD2F635-4B3E-2727-8EF9-019080A60BED}"/>
          </ac:spMkLst>
        </pc:spChg>
        <pc:spChg chg="mod topLvl">
          <ac:chgData name="Bruno Robbs" userId="646f45108becd9d1" providerId="LiveId" clId="{D2A6503E-83DC-43FA-A521-CDEDBA96AF6D}" dt="2022-07-20T15:03:01.130" v="15" actId="1076"/>
          <ac:spMkLst>
            <pc:docMk/>
            <pc:sldMk cId="3371538988" sldId="257"/>
            <ac:spMk id="11" creationId="{5DF48332-21FB-47A3-A834-43CDAB0EFF26}"/>
          </ac:spMkLst>
        </pc:spChg>
        <pc:spChg chg="mod topLvl">
          <ac:chgData name="Bruno Robbs" userId="646f45108becd9d1" providerId="LiveId" clId="{D2A6503E-83DC-43FA-A521-CDEDBA96AF6D}" dt="2022-07-20T15:07:02.783" v="379" actId="1038"/>
          <ac:spMkLst>
            <pc:docMk/>
            <pc:sldMk cId="3371538988" sldId="257"/>
            <ac:spMk id="12" creationId="{7185DE1C-307E-105A-753B-7A0C0B7E9BF7}"/>
          </ac:spMkLst>
        </pc:spChg>
        <pc:spChg chg="mod topLvl">
          <ac:chgData name="Bruno Robbs" userId="646f45108becd9d1" providerId="LiveId" clId="{D2A6503E-83DC-43FA-A521-CDEDBA96AF6D}" dt="2022-07-20T15:06:55.924" v="361" actId="1037"/>
          <ac:spMkLst>
            <pc:docMk/>
            <pc:sldMk cId="3371538988" sldId="257"/>
            <ac:spMk id="13" creationId="{4F49C7F5-7BA9-4A2C-CA24-8CD539945B93}"/>
          </ac:spMkLst>
        </pc:spChg>
        <pc:spChg chg="mod topLvl">
          <ac:chgData name="Bruno Robbs" userId="646f45108becd9d1" providerId="LiveId" clId="{D2A6503E-83DC-43FA-A521-CDEDBA96AF6D}" dt="2022-07-20T15:06:45.892" v="322" actId="1035"/>
          <ac:spMkLst>
            <pc:docMk/>
            <pc:sldMk cId="3371538988" sldId="257"/>
            <ac:spMk id="14" creationId="{E1E01747-B0D4-C72E-0273-18897D33098D}"/>
          </ac:spMkLst>
        </pc:spChg>
        <pc:spChg chg="mod topLvl">
          <ac:chgData name="Bruno Robbs" userId="646f45108becd9d1" providerId="LiveId" clId="{D2A6503E-83DC-43FA-A521-CDEDBA96AF6D}" dt="2022-07-20T15:06:36.079" v="286" actId="1035"/>
          <ac:spMkLst>
            <pc:docMk/>
            <pc:sldMk cId="3371538988" sldId="257"/>
            <ac:spMk id="16" creationId="{AEB51725-42EC-8864-B463-410249625033}"/>
          </ac:spMkLst>
        </pc:spChg>
        <pc:spChg chg="mod topLvl">
          <ac:chgData name="Bruno Robbs" userId="646f45108becd9d1" providerId="LiveId" clId="{D2A6503E-83DC-43FA-A521-CDEDBA96AF6D}" dt="2022-07-20T15:06:22.946" v="243" actId="1037"/>
          <ac:spMkLst>
            <pc:docMk/>
            <pc:sldMk cId="3371538988" sldId="257"/>
            <ac:spMk id="17" creationId="{3B76036D-8FCC-D05E-5D7F-EF261E7999BD}"/>
          </ac:spMkLst>
        </pc:spChg>
        <pc:spChg chg="mod topLvl">
          <ac:chgData name="Bruno Robbs" userId="646f45108becd9d1" providerId="LiveId" clId="{D2A6503E-83DC-43FA-A521-CDEDBA96AF6D}" dt="2022-07-20T15:10:04.714" v="421" actId="1036"/>
          <ac:spMkLst>
            <pc:docMk/>
            <pc:sldMk cId="3371538988" sldId="257"/>
            <ac:spMk id="20" creationId="{43277973-00A2-9E53-E877-CA40553B73A8}"/>
          </ac:spMkLst>
        </pc:spChg>
        <pc:spChg chg="mod topLvl">
          <ac:chgData name="Bruno Robbs" userId="646f45108becd9d1" providerId="LiveId" clId="{D2A6503E-83DC-43FA-A521-CDEDBA96AF6D}" dt="2022-07-20T15:10:08.060" v="425" actId="1036"/>
          <ac:spMkLst>
            <pc:docMk/>
            <pc:sldMk cId="3371538988" sldId="257"/>
            <ac:spMk id="22" creationId="{B7DD0347-3744-13A8-F819-0F5122282F8B}"/>
          </ac:spMkLst>
        </pc:spChg>
        <pc:spChg chg="add mod">
          <ac:chgData name="Bruno Robbs" userId="646f45108becd9d1" providerId="LiveId" clId="{D2A6503E-83DC-43FA-A521-CDEDBA96AF6D}" dt="2022-07-20T15:11:23.209" v="593" actId="1036"/>
          <ac:spMkLst>
            <pc:docMk/>
            <pc:sldMk cId="3371538988" sldId="257"/>
            <ac:spMk id="25" creationId="{0C3AF4F0-4C54-112A-4A38-992F7AFFDB8C}"/>
          </ac:spMkLst>
        </pc:spChg>
        <pc:spChg chg="add mod">
          <ac:chgData name="Bruno Robbs" userId="646f45108becd9d1" providerId="LiveId" clId="{D2A6503E-83DC-43FA-A521-CDEDBA96AF6D}" dt="2022-07-20T15:10:59.026" v="480" actId="1035"/>
          <ac:spMkLst>
            <pc:docMk/>
            <pc:sldMk cId="3371538988" sldId="257"/>
            <ac:spMk id="26" creationId="{58CBE26B-01C2-B98B-1EAF-0EFEEED3F061}"/>
          </ac:spMkLst>
        </pc:spChg>
        <pc:spChg chg="add mod">
          <ac:chgData name="Bruno Robbs" userId="646f45108becd9d1" providerId="LiveId" clId="{D2A6503E-83DC-43FA-A521-CDEDBA96AF6D}" dt="2022-07-20T15:12:14.777" v="667" actId="1035"/>
          <ac:spMkLst>
            <pc:docMk/>
            <pc:sldMk cId="3371538988" sldId="257"/>
            <ac:spMk id="27" creationId="{91443587-322E-63D5-D030-857F3F3203AA}"/>
          </ac:spMkLst>
        </pc:spChg>
        <pc:spChg chg="add mod">
          <ac:chgData name="Bruno Robbs" userId="646f45108becd9d1" providerId="LiveId" clId="{D2A6503E-83DC-43FA-A521-CDEDBA96AF6D}" dt="2022-07-20T15:12:26.045" v="790" actId="1037"/>
          <ac:spMkLst>
            <pc:docMk/>
            <pc:sldMk cId="3371538988" sldId="257"/>
            <ac:spMk id="28" creationId="{2EE70A61-29FB-E32F-9A4D-AD92407ADC1D}"/>
          </ac:spMkLst>
        </pc:spChg>
        <pc:spChg chg="add mod">
          <ac:chgData name="Bruno Robbs" userId="646f45108becd9d1" providerId="LiveId" clId="{D2A6503E-83DC-43FA-A521-CDEDBA96AF6D}" dt="2022-07-20T15:12:02.885" v="610" actId="1038"/>
          <ac:spMkLst>
            <pc:docMk/>
            <pc:sldMk cId="3371538988" sldId="257"/>
            <ac:spMk id="29" creationId="{9FCF9239-B426-C417-356A-AF78060EEFE4}"/>
          </ac:spMkLst>
        </pc:spChg>
        <pc:grpChg chg="add del mod">
          <ac:chgData name="Bruno Robbs" userId="646f45108becd9d1" providerId="LiveId" clId="{D2A6503E-83DC-43FA-A521-CDEDBA96AF6D}" dt="2022-07-20T15:02:41.499" v="8" actId="165"/>
          <ac:grpSpMkLst>
            <pc:docMk/>
            <pc:sldMk cId="3371538988" sldId="257"/>
            <ac:grpSpMk id="5" creationId="{FB81424C-5163-AE4A-F3E9-CB3959FFA182}"/>
          </ac:grpSpMkLst>
        </pc:grpChg>
        <pc:grpChg chg="del mod topLvl">
          <ac:chgData name="Bruno Robbs" userId="646f45108becd9d1" providerId="LiveId" clId="{D2A6503E-83DC-43FA-A521-CDEDBA96AF6D}" dt="2022-07-20T15:02:42.846" v="9" actId="165"/>
          <ac:grpSpMkLst>
            <pc:docMk/>
            <pc:sldMk cId="3371538988" sldId="257"/>
            <ac:grpSpMk id="6" creationId="{DCB4993A-2A0F-1B82-5C6D-D205E0C3F48F}"/>
          </ac:grpSpMkLst>
        </pc:grpChg>
        <pc:grpChg chg="del mod topLvl">
          <ac:chgData name="Bruno Robbs" userId="646f45108becd9d1" providerId="LiveId" clId="{D2A6503E-83DC-43FA-A521-CDEDBA96AF6D}" dt="2022-07-20T15:02:44.506" v="10" actId="165"/>
          <ac:grpSpMkLst>
            <pc:docMk/>
            <pc:sldMk cId="3371538988" sldId="257"/>
            <ac:grpSpMk id="9" creationId="{62F2526A-F190-F0CF-FBAE-3613CC70EFBB}"/>
          </ac:grpSpMkLst>
        </pc:grpChg>
        <pc:grpChg chg="del mod topLvl">
          <ac:chgData name="Bruno Robbs" userId="646f45108becd9d1" providerId="LiveId" clId="{D2A6503E-83DC-43FA-A521-CDEDBA96AF6D}" dt="2022-07-20T15:02:46.059" v="11" actId="165"/>
          <ac:grpSpMkLst>
            <pc:docMk/>
            <pc:sldMk cId="3371538988" sldId="257"/>
            <ac:grpSpMk id="10" creationId="{51952D31-B603-109E-A9C6-CAFAECF0B68B}"/>
          </ac:grpSpMkLst>
        </pc:grpChg>
        <pc:grpChg chg="del mod topLvl">
          <ac:chgData name="Bruno Robbs" userId="646f45108becd9d1" providerId="LiveId" clId="{D2A6503E-83DC-43FA-A521-CDEDBA96AF6D}" dt="2022-07-20T15:02:47.567" v="12" actId="165"/>
          <ac:grpSpMkLst>
            <pc:docMk/>
            <pc:sldMk cId="3371538988" sldId="257"/>
            <ac:grpSpMk id="15" creationId="{E1037CB7-AE55-D8EB-6E75-BD7FE65FC100}"/>
          </ac:grpSpMkLst>
        </pc:grpChg>
        <pc:grpChg chg="del mod topLvl">
          <ac:chgData name="Bruno Robbs" userId="646f45108becd9d1" providerId="LiveId" clId="{D2A6503E-83DC-43FA-A521-CDEDBA96AF6D}" dt="2022-07-20T15:02:49.587" v="13" actId="165"/>
          <ac:grpSpMkLst>
            <pc:docMk/>
            <pc:sldMk cId="3371538988" sldId="257"/>
            <ac:grpSpMk id="18" creationId="{8189CAFC-DBFB-3B37-7CB6-7A0C42D6CEB4}"/>
          </ac:grpSpMkLst>
        </pc:grpChg>
        <pc:graphicFrameChg chg="mod topLvl">
          <ac:chgData name="Bruno Robbs" userId="646f45108becd9d1" providerId="LiveId" clId="{D2A6503E-83DC-43FA-A521-CDEDBA96AF6D}" dt="2022-07-20T15:10:46.390" v="457"/>
          <ac:graphicFrameMkLst>
            <pc:docMk/>
            <pc:sldMk cId="3371538988" sldId="257"/>
            <ac:graphicFrameMk id="8" creationId="{8E4A5562-6B25-12E9-AB8A-9C81B3063947}"/>
          </ac:graphicFrameMkLst>
        </pc:graphicFrameChg>
        <pc:picChg chg="add mod">
          <ac:chgData name="Bruno Robbs" userId="646f45108becd9d1" providerId="LiveId" clId="{D2A6503E-83DC-43FA-A521-CDEDBA96AF6D}" dt="2022-07-20T15:12:34.007" v="793" actId="1037"/>
          <ac:picMkLst>
            <pc:docMk/>
            <pc:sldMk cId="3371538988" sldId="257"/>
            <ac:picMk id="4" creationId="{FAFFF390-E7F6-FEF1-49E1-57AEE77BC880}"/>
          </ac:picMkLst>
        </pc:picChg>
        <pc:picChg chg="mod topLvl">
          <ac:chgData name="Bruno Robbs" userId="646f45108becd9d1" providerId="LiveId" clId="{D2A6503E-83DC-43FA-A521-CDEDBA96AF6D}" dt="2022-07-20T15:05:15.664" v="96" actId="1076"/>
          <ac:picMkLst>
            <pc:docMk/>
            <pc:sldMk cId="3371538988" sldId="257"/>
            <ac:picMk id="23" creationId="{15072767-D506-D8D2-4381-413D440BDDEC}"/>
          </ac:picMkLst>
        </pc:picChg>
        <pc:picChg chg="mod topLvl">
          <ac:chgData name="Bruno Robbs" userId="646f45108becd9d1" providerId="LiveId" clId="{D2A6503E-83DC-43FA-A521-CDEDBA96AF6D}" dt="2022-07-20T15:04:50.093" v="94" actId="1036"/>
          <ac:picMkLst>
            <pc:docMk/>
            <pc:sldMk cId="3371538988" sldId="257"/>
            <ac:picMk id="24" creationId="{3D9DA66A-D640-A1E4-7A60-4AB626E0F1C8}"/>
          </ac:picMkLst>
        </pc:picChg>
        <pc:cxnChg chg="del mod topLvl">
          <ac:chgData name="Bruno Robbs" userId="646f45108becd9d1" providerId="LiveId" clId="{D2A6503E-83DC-43FA-A521-CDEDBA96AF6D}" dt="2022-07-20T15:05:46.162" v="150" actId="478"/>
          <ac:cxnSpMkLst>
            <pc:docMk/>
            <pc:sldMk cId="3371538988" sldId="257"/>
            <ac:cxnSpMk id="19" creationId="{38096F61-A9E5-33DE-E4C8-FBB7CF147F00}"/>
          </ac:cxnSpMkLst>
        </pc:cxnChg>
        <pc:cxnChg chg="del mod topLvl">
          <ac:chgData name="Bruno Robbs" userId="646f45108becd9d1" providerId="LiveId" clId="{D2A6503E-83DC-43FA-A521-CDEDBA96AF6D}" dt="2022-07-20T15:05:56.811" v="180" actId="478"/>
          <ac:cxnSpMkLst>
            <pc:docMk/>
            <pc:sldMk cId="3371538988" sldId="257"/>
            <ac:cxnSpMk id="21" creationId="{B40C4036-CAF3-757F-D23A-51A3A54F47DC}"/>
          </ac:cxnSpMkLst>
        </pc:cxnChg>
      </pc:sldChg>
      <pc:sldChg chg="add del">
        <pc:chgData name="Bruno Robbs" userId="646f45108becd9d1" providerId="LiveId" clId="{D2A6503E-83DC-43FA-A521-CDEDBA96AF6D}" dt="2022-07-20T15:02:26.567" v="4" actId="47"/>
        <pc:sldMkLst>
          <pc:docMk/>
          <pc:sldMk cId="3980032153" sldId="258"/>
        </pc:sldMkLst>
      </pc:sldChg>
      <pc:sldChg chg="add del">
        <pc:chgData name="Bruno Robbs" userId="646f45108becd9d1" providerId="LiveId" clId="{D2A6503E-83DC-43FA-A521-CDEDBA96AF6D}" dt="2022-07-20T15:11:46.238" v="595"/>
        <pc:sldMkLst>
          <pc:docMk/>
          <pc:sldMk cId="4100721949" sldId="258"/>
        </pc:sldMkLst>
      </pc:sldChg>
    </pc:docChg>
  </pc:docChgLst>
  <pc:docChgLst>
    <pc:chgData name="Bruno Robbs" userId="646f45108becd9d1" providerId="LiveId" clId="{B430823A-B8F3-4A6F-A281-CC945E2AA50D}"/>
    <pc:docChg chg="custSel modSld">
      <pc:chgData name="Bruno Robbs" userId="646f45108becd9d1" providerId="LiveId" clId="{B430823A-B8F3-4A6F-A281-CC945E2AA50D}" dt="2023-02-09T19:29:27.902" v="113" actId="20577"/>
      <pc:docMkLst>
        <pc:docMk/>
      </pc:docMkLst>
      <pc:sldChg chg="addSp modSp mod">
        <pc:chgData name="Bruno Robbs" userId="646f45108becd9d1" providerId="LiveId" clId="{B430823A-B8F3-4A6F-A281-CC945E2AA50D}" dt="2023-02-09T19:28:55.898" v="51" actId="313"/>
        <pc:sldMkLst>
          <pc:docMk/>
          <pc:sldMk cId="354287945" sldId="256"/>
        </pc:sldMkLst>
        <pc:spChg chg="add mod">
          <ac:chgData name="Bruno Robbs" userId="646f45108becd9d1" providerId="LiveId" clId="{B430823A-B8F3-4A6F-A281-CC945E2AA50D}" dt="2023-02-09T19:28:55.898" v="51" actId="313"/>
          <ac:spMkLst>
            <pc:docMk/>
            <pc:sldMk cId="354287945" sldId="256"/>
            <ac:spMk id="2" creationId="{BFCEBC2D-CF88-289F-D4F1-A649C8DAF512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9" creationId="{464BC115-6831-33E8-D373-1A0645CDDE1B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15" creationId="{E76FD661-84BF-A63B-48DC-F6F26EEC4E6A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1" creationId="{058FEEC4-CA4A-AC53-6934-D01BCB63C8A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3" creationId="{8D66BF53-FF21-BC84-1C77-031EB4C6BDE4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4" creationId="{C9B5C1AA-9CA7-D866-C758-B9604761BED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5" creationId="{A0DF754A-89AA-4F0B-6BF5-177D23C45462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7" creationId="{13E8FA13-3146-59F3-D27C-E9E2E0AD5ACE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8" creationId="{59375CCD-DE25-BB3A-CE4F-8660FFD4FD3B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29" creationId="{313B50DF-09E6-A520-398B-22439EA94771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30" creationId="{04F52805-1FB6-0376-0799-BA5D7B835EFC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31" creationId="{AE4760CA-EA8A-DAA9-7415-72B09A939B3B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32" creationId="{55C043C8-1C3B-B2A8-0721-E31FB248933D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33" creationId="{D9028844-B6D0-3A36-AFE5-D8A6B25CF1A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34" creationId="{610B84EE-F36E-E28B-22F4-7B47C6D73D8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42" creationId="{D5515D22-47B6-BBED-06D5-2D551FD73E9F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43" creationId="{DCDF9F97-3C99-4657-BD8D-56264C51BBB9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46" creationId="{1DF22B87-C5E6-29DA-EA4E-2FE31EFDB774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47" creationId="{1017F0F9-0B3C-8796-30F4-0EB3F5BAA479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48" creationId="{3D823251-DFDE-ACFB-62B4-83BB3F43AB92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49" creationId="{BD781417-EC3B-8666-8DC3-99D5DE20BEB2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0" creationId="{78E5BEC3-CA47-8838-A31D-0C725EBB419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1" creationId="{92F7B8CB-B284-1ABA-1D4D-E2F934C4660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2" creationId="{7C33B639-C7E4-831D-5936-8C275373A073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3" creationId="{B34028C3-BA4F-E971-75BD-C9FA85AB90F8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5" creationId="{6F7C1241-0D14-4253-939C-C13A9584C90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6" creationId="{3BD5DBF6-5902-729D-29AE-67C801F27770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8" creationId="{5147F6F9-CFCF-2527-C175-A490F8F19A24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59" creationId="{4B882908-7D54-90B7-2AA0-9E088CD49572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60" creationId="{E8B2F53E-EEB8-A5AC-AE55-AD33E56E4B83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61" creationId="{2EB50E82-0802-3358-F495-BFD53E1CC5E5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62" creationId="{EAFE643A-73EF-F816-0133-8984EFD76E4D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64" creationId="{593B7FA6-F40E-5F91-C81E-0AA11766325A}"/>
          </ac:spMkLst>
        </pc:spChg>
        <pc:spChg chg="mod">
          <ac:chgData name="Bruno Robbs" userId="646f45108becd9d1" providerId="LiveId" clId="{B430823A-B8F3-4A6F-A281-CC945E2AA50D}" dt="2023-02-09T19:28:04.426" v="20" actId="1036"/>
          <ac:spMkLst>
            <pc:docMk/>
            <pc:sldMk cId="354287945" sldId="256"/>
            <ac:spMk id="65" creationId="{B0F8EEAE-9640-974C-B21E-D6792C6A9D66}"/>
          </ac:spMkLst>
        </pc:spChg>
        <pc:grpChg chg="mod">
          <ac:chgData name="Bruno Robbs" userId="646f45108becd9d1" providerId="LiveId" clId="{B430823A-B8F3-4A6F-A281-CC945E2AA50D}" dt="2023-02-09T19:28:04.426" v="20" actId="1036"/>
          <ac:grpSpMkLst>
            <pc:docMk/>
            <pc:sldMk cId="354287945" sldId="256"/>
            <ac:grpSpMk id="20" creationId="{62F9E2DC-DB97-5417-D64E-9126D658B30A}"/>
          </ac:grpSpMkLst>
        </pc:grpChg>
        <pc:grpChg chg="mod">
          <ac:chgData name="Bruno Robbs" userId="646f45108becd9d1" providerId="LiveId" clId="{B430823A-B8F3-4A6F-A281-CC945E2AA50D}" dt="2023-02-09T19:28:04.426" v="20" actId="1036"/>
          <ac:grpSpMkLst>
            <pc:docMk/>
            <pc:sldMk cId="354287945" sldId="256"/>
            <ac:grpSpMk id="44" creationId="{1186F6EA-EDEC-DE81-F81E-9BCE7DB117ED}"/>
          </ac:grpSpMkLst>
        </pc:grpChg>
        <pc:grpChg chg="mod">
          <ac:chgData name="Bruno Robbs" userId="646f45108becd9d1" providerId="LiveId" clId="{B430823A-B8F3-4A6F-A281-CC945E2AA50D}" dt="2023-02-09T19:28:04.426" v="20" actId="1036"/>
          <ac:grpSpMkLst>
            <pc:docMk/>
            <pc:sldMk cId="354287945" sldId="256"/>
            <ac:grpSpMk id="45" creationId="{44046C38-6129-559B-8717-02E1A5443B5C}"/>
          </ac:grpSpMkLst>
        </pc:grpChg>
        <pc:grpChg chg="mod">
          <ac:chgData name="Bruno Robbs" userId="646f45108becd9d1" providerId="LiveId" clId="{B430823A-B8F3-4A6F-A281-CC945E2AA50D}" dt="2023-02-09T19:28:04.426" v="20" actId="1036"/>
          <ac:grpSpMkLst>
            <pc:docMk/>
            <pc:sldMk cId="354287945" sldId="256"/>
            <ac:grpSpMk id="54" creationId="{F87214FD-CD57-87F5-3036-EC36F9BA8377}"/>
          </ac:grpSpMkLst>
        </pc:grpChg>
        <pc:grpChg chg="mod">
          <ac:chgData name="Bruno Robbs" userId="646f45108becd9d1" providerId="LiveId" clId="{B430823A-B8F3-4A6F-A281-CC945E2AA50D}" dt="2023-02-09T19:28:04.426" v="20" actId="1036"/>
          <ac:grpSpMkLst>
            <pc:docMk/>
            <pc:sldMk cId="354287945" sldId="256"/>
            <ac:grpSpMk id="63" creationId="{3FA866BF-5893-6E11-39FA-472BB36609C1}"/>
          </ac:grpSpMkLst>
        </pc:grp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6" creationId="{A9F851BD-B5F2-02FA-F6F1-071839D7F925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12" creationId="{E09FB98E-7D26-F1A4-76CD-5B56EE6B6ECF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13" creationId="{3B20D820-C307-4CBB-5074-509FA7C9A9F7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19" creationId="{B5F50E9C-3C12-6A55-7C10-76DA1AF77E37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22" creationId="{0705F4F7-DF1E-3ACE-1DBC-C924ED50EBC2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35" creationId="{D605CA73-B0B2-E328-3873-77A4F7248A7B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36" creationId="{924205D9-F677-4427-38A6-74986D5A3104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37" creationId="{A85BD255-92C4-1CEE-9BF1-05E11A3B1853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40" creationId="{751E9E98-C241-3C37-949C-BC9B7424846D}"/>
          </ac:picMkLst>
        </pc:picChg>
        <pc:picChg chg="mod">
          <ac:chgData name="Bruno Robbs" userId="646f45108becd9d1" providerId="LiveId" clId="{B430823A-B8F3-4A6F-A281-CC945E2AA50D}" dt="2023-02-09T19:28:04.426" v="20" actId="1036"/>
          <ac:picMkLst>
            <pc:docMk/>
            <pc:sldMk cId="354287945" sldId="256"/>
            <ac:picMk id="41" creationId="{A06D7DFC-6EAA-30BD-AF34-FD9C9DF5D604}"/>
          </ac:picMkLst>
        </pc:picChg>
      </pc:sldChg>
      <pc:sldChg chg="addSp modSp mod">
        <pc:chgData name="Bruno Robbs" userId="646f45108becd9d1" providerId="LiveId" clId="{B430823A-B8F3-4A6F-A281-CC945E2AA50D}" dt="2023-02-09T19:29:06.893" v="76" actId="20577"/>
        <pc:sldMkLst>
          <pc:docMk/>
          <pc:sldMk cId="3371538988" sldId="257"/>
        </pc:sldMkLst>
        <pc:spChg chg="add mod">
          <ac:chgData name="Bruno Robbs" userId="646f45108becd9d1" providerId="LiveId" clId="{B430823A-B8F3-4A6F-A281-CC945E2AA50D}" dt="2023-02-09T19:29:06.893" v="76" actId="20577"/>
          <ac:spMkLst>
            <pc:docMk/>
            <pc:sldMk cId="3371538988" sldId="257"/>
            <ac:spMk id="2" creationId="{F05C0C2E-81FF-CA0B-E2B7-AB7E2F8C2321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11" creationId="{5DF48332-21FB-47A3-A834-43CDAB0EFF26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12" creationId="{7185DE1C-307E-105A-753B-7A0C0B7E9BF7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13" creationId="{4F49C7F5-7BA9-4A2C-CA24-8CD539945B93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14" creationId="{E1E01747-B0D4-C72E-0273-18897D33098D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16" creationId="{AEB51725-42EC-8864-B463-410249625033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17" creationId="{3B76036D-8FCC-D05E-5D7F-EF261E7999BD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0" creationId="{43277973-00A2-9E53-E877-CA40553B73A8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2" creationId="{B7DD0347-3744-13A8-F819-0F5122282F8B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5" creationId="{0C3AF4F0-4C54-112A-4A38-992F7AFFDB8C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6" creationId="{58CBE26B-01C2-B98B-1EAF-0EFEEED3F061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7" creationId="{91443587-322E-63D5-D030-857F3F3203AA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8" creationId="{2EE70A61-29FB-E32F-9A4D-AD92407ADC1D}"/>
          </ac:spMkLst>
        </pc:spChg>
        <pc:spChg chg="mod">
          <ac:chgData name="Bruno Robbs" userId="646f45108becd9d1" providerId="LiveId" clId="{B430823A-B8F3-4A6F-A281-CC945E2AA50D}" dt="2023-02-09T19:29:02.805" v="73" actId="1036"/>
          <ac:spMkLst>
            <pc:docMk/>
            <pc:sldMk cId="3371538988" sldId="257"/>
            <ac:spMk id="29" creationId="{9FCF9239-B426-C417-356A-AF78060EEFE4}"/>
          </ac:spMkLst>
        </pc:spChg>
        <pc:graphicFrameChg chg="mod">
          <ac:chgData name="Bruno Robbs" userId="646f45108becd9d1" providerId="LiveId" clId="{B430823A-B8F3-4A6F-A281-CC945E2AA50D}" dt="2023-02-09T19:29:02.805" v="73" actId="1036"/>
          <ac:graphicFrameMkLst>
            <pc:docMk/>
            <pc:sldMk cId="3371538988" sldId="257"/>
            <ac:graphicFrameMk id="8" creationId="{8E4A5562-6B25-12E9-AB8A-9C81B3063947}"/>
          </ac:graphicFrameMkLst>
        </pc:graphicFrameChg>
        <pc:picChg chg="mod">
          <ac:chgData name="Bruno Robbs" userId="646f45108becd9d1" providerId="LiveId" clId="{B430823A-B8F3-4A6F-A281-CC945E2AA50D}" dt="2023-02-09T19:29:02.805" v="73" actId="1036"/>
          <ac:picMkLst>
            <pc:docMk/>
            <pc:sldMk cId="3371538988" sldId="257"/>
            <ac:picMk id="4" creationId="{FAFFF390-E7F6-FEF1-49E1-57AEE77BC880}"/>
          </ac:picMkLst>
        </pc:picChg>
        <pc:picChg chg="mod">
          <ac:chgData name="Bruno Robbs" userId="646f45108becd9d1" providerId="LiveId" clId="{B430823A-B8F3-4A6F-A281-CC945E2AA50D}" dt="2023-02-09T19:29:02.805" v="73" actId="1036"/>
          <ac:picMkLst>
            <pc:docMk/>
            <pc:sldMk cId="3371538988" sldId="257"/>
            <ac:picMk id="23" creationId="{15072767-D506-D8D2-4381-413D440BDDEC}"/>
          </ac:picMkLst>
        </pc:picChg>
        <pc:picChg chg="mod">
          <ac:chgData name="Bruno Robbs" userId="646f45108becd9d1" providerId="LiveId" clId="{B430823A-B8F3-4A6F-A281-CC945E2AA50D}" dt="2023-02-09T19:29:02.805" v="73" actId="1036"/>
          <ac:picMkLst>
            <pc:docMk/>
            <pc:sldMk cId="3371538988" sldId="257"/>
            <ac:picMk id="24" creationId="{3D9DA66A-D640-A1E4-7A60-4AB626E0F1C8}"/>
          </ac:picMkLst>
        </pc:picChg>
      </pc:sldChg>
      <pc:sldChg chg="addSp modSp mod">
        <pc:chgData name="Bruno Robbs" userId="646f45108becd9d1" providerId="LiveId" clId="{B430823A-B8F3-4A6F-A281-CC945E2AA50D}" dt="2023-02-09T19:29:14.482" v="88" actId="20577"/>
        <pc:sldMkLst>
          <pc:docMk/>
          <pc:sldMk cId="3590562119" sldId="258"/>
        </pc:sldMkLst>
        <pc:spChg chg="add mod">
          <ac:chgData name="Bruno Robbs" userId="646f45108becd9d1" providerId="LiveId" clId="{B430823A-B8F3-4A6F-A281-CC945E2AA50D}" dt="2023-02-09T19:29:14.482" v="88" actId="20577"/>
          <ac:spMkLst>
            <pc:docMk/>
            <pc:sldMk cId="3590562119" sldId="258"/>
            <ac:spMk id="2" creationId="{E447F427-6343-52FD-E9F5-8E0B5495682C}"/>
          </ac:spMkLst>
        </pc:spChg>
      </pc:sldChg>
      <pc:sldChg chg="addSp modSp mod">
        <pc:chgData name="Bruno Robbs" userId="646f45108becd9d1" providerId="LiveId" clId="{B430823A-B8F3-4A6F-A281-CC945E2AA50D}" dt="2023-02-09T19:29:27.902" v="113" actId="20577"/>
        <pc:sldMkLst>
          <pc:docMk/>
          <pc:sldMk cId="4064671703" sldId="263"/>
        </pc:sldMkLst>
        <pc:spChg chg="mod">
          <ac:chgData name="Bruno Robbs" userId="646f45108becd9d1" providerId="LiveId" clId="{B430823A-B8F3-4A6F-A281-CC945E2AA50D}" dt="2023-02-09T19:29:24.550" v="110" actId="1036"/>
          <ac:spMkLst>
            <pc:docMk/>
            <pc:sldMk cId="4064671703" sldId="263"/>
            <ac:spMk id="3" creationId="{E4D9FF51-A186-90C1-4352-04B45649D663}"/>
          </ac:spMkLst>
        </pc:spChg>
        <pc:spChg chg="add mod">
          <ac:chgData name="Bruno Robbs" userId="646f45108becd9d1" providerId="LiveId" clId="{B430823A-B8F3-4A6F-A281-CC945E2AA50D}" dt="2023-02-09T19:29:27.902" v="113" actId="20577"/>
          <ac:spMkLst>
            <pc:docMk/>
            <pc:sldMk cId="4064671703" sldId="263"/>
            <ac:spMk id="4" creationId="{F4262EB9-549B-8CFE-907E-51CD7027F182}"/>
          </ac:spMkLst>
        </pc:spChg>
        <pc:graphicFrameChg chg="mod">
          <ac:chgData name="Bruno Robbs" userId="646f45108becd9d1" providerId="LiveId" clId="{B430823A-B8F3-4A6F-A281-CC945E2AA50D}" dt="2023-02-09T19:29:24.550" v="110" actId="1036"/>
          <ac:graphicFrameMkLst>
            <pc:docMk/>
            <pc:sldMk cId="4064671703" sldId="263"/>
            <ac:graphicFrameMk id="2" creationId="{D5EB38B5-953A-F6DC-A625-2B00BFD328E2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10254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12350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11467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50189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72032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05804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0936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5134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6176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48985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82079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4EC12-37C6-42E2-B85E-8644641177F5}" type="datetimeFigureOut">
              <a:rPr lang="pt-BR" smtClean="0"/>
              <a:t>21/07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A3250-EF65-4344-8BBC-BE0AAEEC16F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6755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>
            <a:extLst>
              <a:ext uri="{FF2B5EF4-FFF2-40B4-BE49-F238E27FC236}">
                <a16:creationId xmlns:a16="http://schemas.microsoft.com/office/drawing/2014/main" id="{A9F851BD-B5F2-02FA-F6F1-071839D7F9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628" y="2228409"/>
            <a:ext cx="3836756" cy="3052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Flowchart: Merge 104">
            <a:extLst>
              <a:ext uri="{FF2B5EF4-FFF2-40B4-BE49-F238E27FC236}">
                <a16:creationId xmlns:a16="http://schemas.microsoft.com/office/drawing/2014/main" id="{04F52805-1FB6-0376-0799-BA5D7B835EFC}"/>
              </a:ext>
            </a:extLst>
          </p:cNvPr>
          <p:cNvSpPr/>
          <p:nvPr/>
        </p:nvSpPr>
        <p:spPr bwMode="auto">
          <a:xfrm rot="16200000">
            <a:off x="673879" y="3981485"/>
            <a:ext cx="171450" cy="107950"/>
          </a:xfrm>
          <a:prstGeom prst="flowChartMerge">
            <a:avLst/>
          </a:prstGeom>
          <a:solidFill>
            <a:schemeClr val="tx1"/>
          </a:solidFill>
          <a:ln w="3175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/>
          </a:p>
        </p:txBody>
      </p:sp>
      <p:sp>
        <p:nvSpPr>
          <p:cNvPr id="31" name="TextBox 105">
            <a:extLst>
              <a:ext uri="{FF2B5EF4-FFF2-40B4-BE49-F238E27FC236}">
                <a16:creationId xmlns:a16="http://schemas.microsoft.com/office/drawing/2014/main" id="{AE4760CA-EA8A-DAA9-7415-72B09A939B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54" y="3884789"/>
            <a:ext cx="721538" cy="3231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500">
                <a:latin typeface="Calibri" panose="020F0502020204030204" pitchFamily="34" charset="0"/>
              </a:rPr>
              <a:t>15 kDa</a:t>
            </a:r>
          </a:p>
        </p:txBody>
      </p:sp>
      <p:sp>
        <p:nvSpPr>
          <p:cNvPr id="28" name="CaixaDeTexto 36">
            <a:extLst>
              <a:ext uri="{FF2B5EF4-FFF2-40B4-BE49-F238E27FC236}">
                <a16:creationId xmlns:a16="http://schemas.microsoft.com/office/drawing/2014/main" id="{59375CCD-DE25-BB3A-CE4F-8660FFD4F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8567" y="1939894"/>
            <a:ext cx="475236" cy="369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 dirty="0">
                <a:latin typeface="Calibri" panose="020F0502020204030204" pitchFamily="34" charset="0"/>
              </a:rPr>
              <a:t>IEC</a:t>
            </a:r>
          </a:p>
        </p:txBody>
      </p:sp>
      <p:sp>
        <p:nvSpPr>
          <p:cNvPr id="29" name="TextBox 8">
            <a:extLst>
              <a:ext uri="{FF2B5EF4-FFF2-40B4-BE49-F238E27FC236}">
                <a16:creationId xmlns:a16="http://schemas.microsoft.com/office/drawing/2014/main" id="{313B50DF-09E6-A520-398B-22439EA947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79" y="1937910"/>
            <a:ext cx="1094790" cy="369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>
                <a:latin typeface="Calibri" panose="020F0502020204030204" pitchFamily="34" charset="0"/>
              </a:rPr>
              <a:t>Pre</a:t>
            </a:r>
          </a:p>
        </p:txBody>
      </p:sp>
      <p:sp>
        <p:nvSpPr>
          <p:cNvPr id="27" name="TextBox 101">
            <a:extLst>
              <a:ext uri="{FF2B5EF4-FFF2-40B4-BE49-F238E27FC236}">
                <a16:creationId xmlns:a16="http://schemas.microsoft.com/office/drawing/2014/main" id="{13E8FA13-3146-59F3-D27C-E9E2E0AD5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7567" y="1949781"/>
            <a:ext cx="1094790" cy="369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>
                <a:latin typeface="Calibri" panose="020F0502020204030204" pitchFamily="34" charset="0"/>
              </a:rPr>
              <a:t>Pos</a:t>
            </a:r>
          </a:p>
        </p:txBody>
      </p:sp>
      <p:pic>
        <p:nvPicPr>
          <p:cNvPr id="19" name="Picture 92">
            <a:extLst>
              <a:ext uri="{FF2B5EF4-FFF2-40B4-BE49-F238E27FC236}">
                <a16:creationId xmlns:a16="http://schemas.microsoft.com/office/drawing/2014/main" id="{B5F50E9C-3C12-6A55-7C10-76DA1AF77E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000"/>
          <a:stretch>
            <a:fillRect/>
          </a:stretch>
        </p:blipFill>
        <p:spPr bwMode="auto">
          <a:xfrm>
            <a:off x="7710311" y="2298853"/>
            <a:ext cx="582226" cy="2516069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0" name="Group 93">
            <a:extLst>
              <a:ext uri="{FF2B5EF4-FFF2-40B4-BE49-F238E27FC236}">
                <a16:creationId xmlns:a16="http://schemas.microsoft.com/office/drawing/2014/main" id="{62F9E2DC-DB97-5417-D64E-9126D658B30A}"/>
              </a:ext>
            </a:extLst>
          </p:cNvPr>
          <p:cNvGrpSpPr>
            <a:grpSpLocks/>
          </p:cNvGrpSpPr>
          <p:nvPr/>
        </p:nvGrpSpPr>
        <p:grpSpPr bwMode="auto">
          <a:xfrm>
            <a:off x="6863782" y="3321563"/>
            <a:ext cx="774534" cy="323179"/>
            <a:chOff x="5597522" y="4758497"/>
            <a:chExt cx="774678" cy="323165"/>
          </a:xfrm>
        </p:grpSpPr>
        <p:sp>
          <p:nvSpPr>
            <p:cNvPr id="24" name="Flowchart: Merge 98">
              <a:extLst>
                <a:ext uri="{FF2B5EF4-FFF2-40B4-BE49-F238E27FC236}">
                  <a16:creationId xmlns:a16="http://schemas.microsoft.com/office/drawing/2014/main" id="{C9B5C1AA-9CA7-D866-C758-B9604761BED5}"/>
                </a:ext>
              </a:extLst>
            </p:cNvPr>
            <p:cNvSpPr/>
            <p:nvPr/>
          </p:nvSpPr>
          <p:spPr>
            <a:xfrm rot="16200000">
              <a:off x="6231625" y="4865158"/>
              <a:ext cx="173031" cy="107970"/>
            </a:xfrm>
            <a:prstGeom prst="flowChartMerge">
              <a:avLst/>
            </a:prstGeom>
            <a:solidFill>
              <a:schemeClr val="tx1"/>
            </a:solidFill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BR"/>
            </a:p>
          </p:txBody>
        </p:sp>
        <p:sp>
          <p:nvSpPr>
            <p:cNvPr id="25" name="TextBox 99">
              <a:extLst>
                <a:ext uri="{FF2B5EF4-FFF2-40B4-BE49-F238E27FC236}">
                  <a16:creationId xmlns:a16="http://schemas.microsoft.com/office/drawing/2014/main" id="{A0DF754A-89AA-4F0B-6BF5-177D23C454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97522" y="4758497"/>
              <a:ext cx="721672" cy="3231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pt-BR" altLang="pt-BR" sz="1500">
                  <a:latin typeface="Calibri" panose="020F0502020204030204" pitchFamily="34" charset="0"/>
                </a:rPr>
                <a:t>15 kDa</a:t>
              </a:r>
            </a:p>
          </p:txBody>
        </p:sp>
      </p:grpSp>
      <p:sp>
        <p:nvSpPr>
          <p:cNvPr id="21" name="TextBox 94">
            <a:extLst>
              <a:ext uri="{FF2B5EF4-FFF2-40B4-BE49-F238E27FC236}">
                <a16:creationId xmlns:a16="http://schemas.microsoft.com/office/drawing/2014/main" id="{058FEEC4-CA4A-AC53-6934-D01BCB63C8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29491" y="1981211"/>
            <a:ext cx="301630" cy="3693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1800" b="1">
                <a:latin typeface="Calibri" panose="020F0502020204030204" pitchFamily="34" charset="0"/>
              </a:rPr>
              <a:t>1</a:t>
            </a:r>
          </a:p>
        </p:txBody>
      </p:sp>
      <p:pic>
        <p:nvPicPr>
          <p:cNvPr id="22" name="Imagem 111" descr="westenbvlotti.tif">
            <a:extLst>
              <a:ext uri="{FF2B5EF4-FFF2-40B4-BE49-F238E27FC236}">
                <a16:creationId xmlns:a16="http://schemas.microsoft.com/office/drawing/2014/main" id="{0705F4F7-DF1E-3ACE-1DBC-C924ED50EB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13323" y="2307235"/>
            <a:ext cx="455802" cy="2520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CaixaDeTexto 42">
            <a:extLst>
              <a:ext uri="{FF2B5EF4-FFF2-40B4-BE49-F238E27FC236}">
                <a16:creationId xmlns:a16="http://schemas.microsoft.com/office/drawing/2014/main" id="{8D66BF53-FF21-BC84-1C77-031EB4C6BD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64527" y="1978154"/>
            <a:ext cx="551652" cy="4001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sz="2000">
                <a:latin typeface="Calibri" panose="020F0502020204030204" pitchFamily="34" charset="0"/>
              </a:rPr>
              <a:t>WB</a:t>
            </a:r>
          </a:p>
        </p:txBody>
      </p:sp>
      <p:sp>
        <p:nvSpPr>
          <p:cNvPr id="15" name="Rectangle 77">
            <a:extLst>
              <a:ext uri="{FF2B5EF4-FFF2-40B4-BE49-F238E27FC236}">
                <a16:creationId xmlns:a16="http://schemas.microsoft.com/office/drawing/2014/main" id="{E76FD661-84BF-A63B-48DC-F6F26EEC4E6A}"/>
              </a:ext>
            </a:extLst>
          </p:cNvPr>
          <p:cNvSpPr/>
          <p:nvPr/>
        </p:nvSpPr>
        <p:spPr bwMode="auto">
          <a:xfrm>
            <a:off x="5383991" y="5113372"/>
            <a:ext cx="561975" cy="2190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 dirty="0"/>
          </a:p>
        </p:txBody>
      </p:sp>
      <p:sp>
        <p:nvSpPr>
          <p:cNvPr id="9" name="TextBox 62">
            <a:extLst>
              <a:ext uri="{FF2B5EF4-FFF2-40B4-BE49-F238E27FC236}">
                <a16:creationId xmlns:a16="http://schemas.microsoft.com/office/drawing/2014/main" id="{464BC115-6831-33E8-D373-1A0645CDDE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316" y="1566897"/>
            <a:ext cx="43313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A</a:t>
            </a:r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E09FB98E-7D26-F1A4-76CD-5B56EE6B6E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81" t="2325" r="5473" b="5247"/>
          <a:stretch>
            <a:fillRect/>
          </a:stretch>
        </p:blipFill>
        <p:spPr bwMode="auto">
          <a:xfrm>
            <a:off x="879671" y="2293503"/>
            <a:ext cx="990177" cy="2458887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7">
            <a:extLst>
              <a:ext uri="{FF2B5EF4-FFF2-40B4-BE49-F238E27FC236}">
                <a16:creationId xmlns:a16="http://schemas.microsoft.com/office/drawing/2014/main" id="{3B20D820-C307-4CBB-5074-509FA7C9A9F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47" r="18301"/>
          <a:stretch>
            <a:fillRect/>
          </a:stretch>
        </p:blipFill>
        <p:spPr bwMode="auto">
          <a:xfrm>
            <a:off x="2050053" y="2292679"/>
            <a:ext cx="392914" cy="2447011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Rectangle 5">
            <a:extLst>
              <a:ext uri="{FF2B5EF4-FFF2-40B4-BE49-F238E27FC236}">
                <a16:creationId xmlns:a16="http://schemas.microsoft.com/office/drawing/2014/main" id="{610B84EE-F36E-E28B-22F4-7B47C6D73D8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912629" y="6474907"/>
            <a:ext cx="16224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l-GR" altLang="pt-BR" sz="1800" b="1" dirty="0">
                <a:latin typeface="Calibri" panose="020F0502020204030204" pitchFamily="34" charset="0"/>
              </a:rPr>
              <a:t>α</a:t>
            </a:r>
            <a:r>
              <a:rPr lang="pt-BR" altLang="pt-BR" sz="1800" b="1" dirty="0">
                <a:latin typeface="Calibri" panose="020F0502020204030204" pitchFamily="34" charset="0"/>
              </a:rPr>
              <a:t>-</a:t>
            </a:r>
            <a:r>
              <a:rPr lang="pt-BR" altLang="pt-BR" sz="1800" b="1" dirty="0" err="1">
                <a:latin typeface="Calibri" panose="020F0502020204030204" pitchFamily="34" charset="0"/>
              </a:rPr>
              <a:t>sin</a:t>
            </a:r>
            <a:r>
              <a:rPr lang="pt-BR" altLang="pt-BR" sz="1800" b="1" dirty="0">
                <a:latin typeface="Calibri" panose="020F0502020204030204" pitchFamily="34" charset="0"/>
              </a:rPr>
              <a:t> A30P 10d</a:t>
            </a:r>
          </a:p>
        </p:txBody>
      </p:sp>
      <p:pic>
        <p:nvPicPr>
          <p:cNvPr id="35" name="Picture 8">
            <a:extLst>
              <a:ext uri="{FF2B5EF4-FFF2-40B4-BE49-F238E27FC236}">
                <a16:creationId xmlns:a16="http://schemas.microsoft.com/office/drawing/2014/main" id="{D605CA73-B0B2-E328-3873-77A4F7248A7B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2591" y="5614482"/>
            <a:ext cx="2478796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45" name="Agrupar 44">
            <a:extLst>
              <a:ext uri="{FF2B5EF4-FFF2-40B4-BE49-F238E27FC236}">
                <a16:creationId xmlns:a16="http://schemas.microsoft.com/office/drawing/2014/main" id="{44046C38-6129-559B-8717-02E1A5443B5C}"/>
              </a:ext>
            </a:extLst>
          </p:cNvPr>
          <p:cNvGrpSpPr/>
          <p:nvPr/>
        </p:nvGrpSpPr>
        <p:grpSpPr>
          <a:xfrm>
            <a:off x="3377781" y="5641193"/>
            <a:ext cx="3141217" cy="2160000"/>
            <a:chOff x="5284775" y="4872612"/>
            <a:chExt cx="3141217" cy="2160000"/>
          </a:xfrm>
        </p:grpSpPr>
        <p:sp>
          <p:nvSpPr>
            <p:cNvPr id="33" name="Rectangle 4">
              <a:extLst>
                <a:ext uri="{FF2B5EF4-FFF2-40B4-BE49-F238E27FC236}">
                  <a16:creationId xmlns:a16="http://schemas.microsoft.com/office/drawing/2014/main" id="{D9028844-B6D0-3A36-AFE5-D8A6B25CF1A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658506" y="5689381"/>
              <a:ext cx="1622425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l-GR" altLang="pt-BR" sz="1800" b="1" dirty="0">
                  <a:latin typeface="Calibri" panose="020F0502020204030204" pitchFamily="34" charset="0"/>
                </a:rPr>
                <a:t>α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-</a:t>
              </a:r>
              <a:r>
                <a:rPr lang="pt-BR" altLang="pt-BR" sz="1800" b="1" dirty="0" err="1">
                  <a:latin typeface="Calibri" panose="020F0502020204030204" pitchFamily="34" charset="0"/>
                </a:rPr>
                <a:t>sin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 A30P 24h</a:t>
              </a:r>
            </a:p>
          </p:txBody>
        </p:sp>
        <p:pic>
          <p:nvPicPr>
            <p:cNvPr id="36" name="Picture 9">
              <a:extLst>
                <a:ext uri="{FF2B5EF4-FFF2-40B4-BE49-F238E27FC236}">
                  <a16:creationId xmlns:a16="http://schemas.microsoft.com/office/drawing/2014/main" id="{924205D9-F677-4427-38A6-74986D5A310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81636" y="4872612"/>
              <a:ext cx="2844356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4" name="Agrupar 43">
            <a:extLst>
              <a:ext uri="{FF2B5EF4-FFF2-40B4-BE49-F238E27FC236}">
                <a16:creationId xmlns:a16="http://schemas.microsoft.com/office/drawing/2014/main" id="{1186F6EA-EDEC-DE81-F81E-9BCE7DB117ED}"/>
              </a:ext>
            </a:extLst>
          </p:cNvPr>
          <p:cNvGrpSpPr>
            <a:grpSpLocks noChangeAspect="1"/>
          </p:cNvGrpSpPr>
          <p:nvPr/>
        </p:nvGrpSpPr>
        <p:grpSpPr>
          <a:xfrm>
            <a:off x="292087" y="5670145"/>
            <a:ext cx="3120857" cy="2160000"/>
            <a:chOff x="1231886" y="4904362"/>
            <a:chExt cx="3120857" cy="2160000"/>
          </a:xfrm>
        </p:grpSpPr>
        <p:sp>
          <p:nvSpPr>
            <p:cNvPr id="32" name="Rectangle 3">
              <a:extLst>
                <a:ext uri="{FF2B5EF4-FFF2-40B4-BE49-F238E27FC236}">
                  <a16:creationId xmlns:a16="http://schemas.microsoft.com/office/drawing/2014/main" id="{55C043C8-1C3B-B2A8-0721-E31FB248933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3561" y="5739388"/>
              <a:ext cx="1506537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l-GR" altLang="pt-BR" sz="1800" b="1" dirty="0">
                  <a:latin typeface="Calibri" panose="020F0502020204030204" pitchFamily="34" charset="0"/>
                </a:rPr>
                <a:t>α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-</a:t>
              </a:r>
              <a:r>
                <a:rPr lang="pt-BR" altLang="pt-BR" sz="1800" b="1" dirty="0" err="1">
                  <a:latin typeface="Calibri" panose="020F0502020204030204" pitchFamily="34" charset="0"/>
                </a:rPr>
                <a:t>sin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 A30P 0h</a:t>
              </a:r>
            </a:p>
          </p:txBody>
        </p:sp>
        <p:pic>
          <p:nvPicPr>
            <p:cNvPr id="37" name="Picture 10">
              <a:extLst>
                <a:ext uri="{FF2B5EF4-FFF2-40B4-BE49-F238E27FC236}">
                  <a16:creationId xmlns:a16="http://schemas.microsoft.com/office/drawing/2014/main" id="{A85BD255-92C4-1CEE-9BF1-05E11A3B1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79"/>
            <a:stretch>
              <a:fillRect/>
            </a:stretch>
          </p:blipFill>
          <p:spPr bwMode="auto">
            <a:xfrm>
              <a:off x="1522398" y="4904362"/>
              <a:ext cx="2830345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42" name="TextBox 62">
            <a:extLst>
              <a:ext uri="{FF2B5EF4-FFF2-40B4-BE49-F238E27FC236}">
                <a16:creationId xmlns:a16="http://schemas.microsoft.com/office/drawing/2014/main" id="{D5515D22-47B6-BBED-06D5-2D551FD73E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4616" y="1566897"/>
            <a:ext cx="415498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B</a:t>
            </a:r>
          </a:p>
        </p:txBody>
      </p:sp>
      <p:sp>
        <p:nvSpPr>
          <p:cNvPr id="43" name="TextBox 62">
            <a:extLst>
              <a:ext uri="{FF2B5EF4-FFF2-40B4-BE49-F238E27FC236}">
                <a16:creationId xmlns:a16="http://schemas.microsoft.com/office/drawing/2014/main" id="{DCDF9F97-3C99-4657-BD8D-56264C51BB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8116" y="1566897"/>
            <a:ext cx="40267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C</a:t>
            </a:r>
          </a:p>
        </p:txBody>
      </p:sp>
      <p:sp>
        <p:nvSpPr>
          <p:cNvPr id="46" name="TextBox 62">
            <a:extLst>
              <a:ext uri="{FF2B5EF4-FFF2-40B4-BE49-F238E27FC236}">
                <a16:creationId xmlns:a16="http://schemas.microsoft.com/office/drawing/2014/main" id="{1DF22B87-C5E6-29DA-EA4E-2FE31EFDB7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016" y="5072097"/>
            <a:ext cx="44275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D</a:t>
            </a:r>
          </a:p>
        </p:txBody>
      </p:sp>
      <p:sp>
        <p:nvSpPr>
          <p:cNvPr id="47" name="TextBox 62">
            <a:extLst>
              <a:ext uri="{FF2B5EF4-FFF2-40B4-BE49-F238E27FC236}">
                <a16:creationId xmlns:a16="http://schemas.microsoft.com/office/drawing/2014/main" id="{1017F0F9-0B3C-8796-30F4-0EB3F5BAA4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47316" y="5072097"/>
            <a:ext cx="38504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E</a:t>
            </a:r>
          </a:p>
        </p:txBody>
      </p:sp>
      <p:sp>
        <p:nvSpPr>
          <p:cNvPr id="48" name="TextBox 62">
            <a:extLst>
              <a:ext uri="{FF2B5EF4-FFF2-40B4-BE49-F238E27FC236}">
                <a16:creationId xmlns:a16="http://schemas.microsoft.com/office/drawing/2014/main" id="{3D823251-DFDE-ACFB-62B4-83BB3F43AB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0816" y="5072097"/>
            <a:ext cx="37382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F</a:t>
            </a:r>
          </a:p>
        </p:txBody>
      </p:sp>
      <p:grpSp>
        <p:nvGrpSpPr>
          <p:cNvPr id="54" name="Agrupar 53">
            <a:extLst>
              <a:ext uri="{FF2B5EF4-FFF2-40B4-BE49-F238E27FC236}">
                <a16:creationId xmlns:a16="http://schemas.microsoft.com/office/drawing/2014/main" id="{F87214FD-CD57-87F5-3036-EC36F9BA8377}"/>
              </a:ext>
            </a:extLst>
          </p:cNvPr>
          <p:cNvGrpSpPr>
            <a:grpSpLocks noChangeAspect="1"/>
          </p:cNvGrpSpPr>
          <p:nvPr/>
        </p:nvGrpSpPr>
        <p:grpSpPr>
          <a:xfrm>
            <a:off x="1356279" y="8001291"/>
            <a:ext cx="5438221" cy="3009101"/>
            <a:chOff x="797479" y="6575108"/>
            <a:chExt cx="6506940" cy="3600450"/>
          </a:xfrm>
        </p:grpSpPr>
        <p:pic>
          <p:nvPicPr>
            <p:cNvPr id="40" name="Imagem 3">
              <a:extLst>
                <a:ext uri="{FF2B5EF4-FFF2-40B4-BE49-F238E27FC236}">
                  <a16:creationId xmlns:a16="http://schemas.microsoft.com/office/drawing/2014/main" id="{751E9E98-C241-3C37-949C-BC9B7424846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13" b="72334"/>
            <a:stretch/>
          </p:blipFill>
          <p:spPr bwMode="auto">
            <a:xfrm>
              <a:off x="797479" y="6575108"/>
              <a:ext cx="6506940" cy="3600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9" name="CaixaDeTexto 48">
              <a:extLst>
                <a:ext uri="{FF2B5EF4-FFF2-40B4-BE49-F238E27FC236}">
                  <a16:creationId xmlns:a16="http://schemas.microsoft.com/office/drawing/2014/main" id="{BD781417-EC3B-8666-8DC3-99D5DE20BEB2}"/>
                </a:ext>
              </a:extLst>
            </p:cNvPr>
            <p:cNvSpPr txBox="1"/>
            <p:nvPr/>
          </p:nvSpPr>
          <p:spPr>
            <a:xfrm>
              <a:off x="1348932" y="6679809"/>
              <a:ext cx="50526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0h</a:t>
              </a:r>
            </a:p>
          </p:txBody>
        </p:sp>
        <p:sp>
          <p:nvSpPr>
            <p:cNvPr id="50" name="CaixaDeTexto 49">
              <a:extLst>
                <a:ext uri="{FF2B5EF4-FFF2-40B4-BE49-F238E27FC236}">
                  <a16:creationId xmlns:a16="http://schemas.microsoft.com/office/drawing/2014/main" id="{78E5BEC3-CA47-8838-A31D-0C725EBB4195}"/>
                </a:ext>
              </a:extLst>
            </p:cNvPr>
            <p:cNvSpPr txBox="1"/>
            <p:nvPr/>
          </p:nvSpPr>
          <p:spPr>
            <a:xfrm>
              <a:off x="2872932" y="6679809"/>
              <a:ext cx="66075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24h</a:t>
              </a:r>
            </a:p>
          </p:txBody>
        </p:sp>
        <p:sp>
          <p:nvSpPr>
            <p:cNvPr id="51" name="CaixaDeTexto 50">
              <a:extLst>
                <a:ext uri="{FF2B5EF4-FFF2-40B4-BE49-F238E27FC236}">
                  <a16:creationId xmlns:a16="http://schemas.microsoft.com/office/drawing/2014/main" id="{92F7B8CB-B284-1ABA-1D4D-E2F934C46605}"/>
                </a:ext>
              </a:extLst>
            </p:cNvPr>
            <p:cNvSpPr txBox="1"/>
            <p:nvPr/>
          </p:nvSpPr>
          <p:spPr>
            <a:xfrm>
              <a:off x="4282632" y="6679809"/>
              <a:ext cx="660758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48h</a:t>
              </a:r>
            </a:p>
          </p:txBody>
        </p:sp>
        <p:sp>
          <p:nvSpPr>
            <p:cNvPr id="52" name="CaixaDeTexto 51">
              <a:extLst>
                <a:ext uri="{FF2B5EF4-FFF2-40B4-BE49-F238E27FC236}">
                  <a16:creationId xmlns:a16="http://schemas.microsoft.com/office/drawing/2014/main" id="{7C33B639-C7E4-831D-5936-8C275373A073}"/>
                </a:ext>
              </a:extLst>
            </p:cNvPr>
            <p:cNvSpPr txBox="1"/>
            <p:nvPr/>
          </p:nvSpPr>
          <p:spPr>
            <a:xfrm>
              <a:off x="5501832" y="6679809"/>
              <a:ext cx="1143775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pt-BR" sz="2400" b="1" dirty="0"/>
                <a:t>10 </a:t>
              </a:r>
              <a:r>
                <a:rPr lang="pt-BR" sz="2400" b="1" dirty="0" err="1"/>
                <a:t>days</a:t>
              </a:r>
              <a:endParaRPr lang="pt-BR" sz="2400" b="1" dirty="0"/>
            </a:p>
          </p:txBody>
        </p:sp>
      </p:grpSp>
      <p:sp>
        <p:nvSpPr>
          <p:cNvPr id="53" name="CaixaDeTexto 52">
            <a:extLst>
              <a:ext uri="{FF2B5EF4-FFF2-40B4-BE49-F238E27FC236}">
                <a16:creationId xmlns:a16="http://schemas.microsoft.com/office/drawing/2014/main" id="{B34028C3-BA4F-E971-75BD-C9FA85AB90F8}"/>
              </a:ext>
            </a:extLst>
          </p:cNvPr>
          <p:cNvSpPr txBox="1"/>
          <p:nvPr/>
        </p:nvSpPr>
        <p:spPr>
          <a:xfrm>
            <a:off x="25733" y="9393923"/>
            <a:ext cx="12740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b="1" dirty="0"/>
              <a:t>A11</a:t>
            </a:r>
          </a:p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Oligomer</a:t>
            </a:r>
            <a:endParaRPr lang="pt-BR" b="1" dirty="0"/>
          </a:p>
        </p:txBody>
      </p:sp>
      <p:sp>
        <p:nvSpPr>
          <p:cNvPr id="55" name="CaixaDeTexto 54">
            <a:extLst>
              <a:ext uri="{FF2B5EF4-FFF2-40B4-BE49-F238E27FC236}">
                <a16:creationId xmlns:a16="http://schemas.microsoft.com/office/drawing/2014/main" id="{6F7C1241-0D14-4253-939C-C13A9584C905}"/>
              </a:ext>
            </a:extLst>
          </p:cNvPr>
          <p:cNvSpPr txBox="1"/>
          <p:nvPr/>
        </p:nvSpPr>
        <p:spPr>
          <a:xfrm>
            <a:off x="255514" y="10194023"/>
            <a:ext cx="8739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BR" b="1" dirty="0"/>
              <a:t>OC</a:t>
            </a:r>
          </a:p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Fiber</a:t>
            </a:r>
            <a:endParaRPr lang="pt-BR" b="1" dirty="0"/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id="{3BD5DBF6-5902-729D-29AE-67C801F27770}"/>
              </a:ext>
            </a:extLst>
          </p:cNvPr>
          <p:cNvSpPr txBox="1"/>
          <p:nvPr/>
        </p:nvSpPr>
        <p:spPr>
          <a:xfrm>
            <a:off x="25195" y="8597211"/>
            <a:ext cx="13340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syn</a:t>
            </a:r>
            <a:endParaRPr lang="pt-BR" b="1" dirty="0"/>
          </a:p>
          <a:p>
            <a:pPr algn="ctr"/>
            <a:r>
              <a:rPr lang="el-GR" b="1" dirty="0"/>
              <a:t>α</a:t>
            </a:r>
            <a:r>
              <a:rPr lang="pt-BR" b="1" dirty="0"/>
              <a:t>-</a:t>
            </a:r>
            <a:r>
              <a:rPr lang="pt-BR" b="1" dirty="0" err="1"/>
              <a:t>monomer</a:t>
            </a:r>
            <a:endParaRPr lang="pt-BR" b="1" dirty="0"/>
          </a:p>
        </p:txBody>
      </p:sp>
      <p:grpSp>
        <p:nvGrpSpPr>
          <p:cNvPr id="63" name="Agrupar 62">
            <a:extLst>
              <a:ext uri="{FF2B5EF4-FFF2-40B4-BE49-F238E27FC236}">
                <a16:creationId xmlns:a16="http://schemas.microsoft.com/office/drawing/2014/main" id="{3FA866BF-5893-6E11-39FA-472BB36609C1}"/>
              </a:ext>
            </a:extLst>
          </p:cNvPr>
          <p:cNvGrpSpPr/>
          <p:nvPr/>
        </p:nvGrpSpPr>
        <p:grpSpPr>
          <a:xfrm>
            <a:off x="6436094" y="8188689"/>
            <a:ext cx="2799808" cy="3009101"/>
            <a:chOff x="6486894" y="6813306"/>
            <a:chExt cx="2799808" cy="3009101"/>
          </a:xfrm>
        </p:grpSpPr>
        <p:pic>
          <p:nvPicPr>
            <p:cNvPr id="41" name="Imagem 40">
              <a:extLst>
                <a:ext uri="{FF2B5EF4-FFF2-40B4-BE49-F238E27FC236}">
                  <a16:creationId xmlns:a16="http://schemas.microsoft.com/office/drawing/2014/main" id="{A06D7DFC-6EAA-30BD-AF34-FD9C9DF5D604}"/>
                </a:ext>
              </a:extLst>
            </p:cNvPr>
            <p:cNvPicPr/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45" t="28854" r="28916" b="43946"/>
            <a:stretch/>
          </p:blipFill>
          <p:spPr>
            <a:xfrm>
              <a:off x="6486894" y="6813306"/>
              <a:ext cx="2799808" cy="3009101"/>
            </a:xfrm>
            <a:prstGeom prst="rect">
              <a:avLst/>
            </a:prstGeom>
          </p:spPr>
        </p:pic>
        <p:sp>
          <p:nvSpPr>
            <p:cNvPr id="58" name="CaixaDeTexto 57">
              <a:extLst>
                <a:ext uri="{FF2B5EF4-FFF2-40B4-BE49-F238E27FC236}">
                  <a16:creationId xmlns:a16="http://schemas.microsoft.com/office/drawing/2014/main" id="{5147F6F9-CFCF-2527-C175-A490F8F19A24}"/>
                </a:ext>
              </a:extLst>
            </p:cNvPr>
            <p:cNvSpPr txBox="1"/>
            <p:nvPr/>
          </p:nvSpPr>
          <p:spPr>
            <a:xfrm>
              <a:off x="7558744" y="9154505"/>
              <a:ext cx="492443" cy="360035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0h</a:t>
              </a:r>
            </a:p>
          </p:txBody>
        </p:sp>
        <p:sp>
          <p:nvSpPr>
            <p:cNvPr id="59" name="CaixaDeTexto 58">
              <a:extLst>
                <a:ext uri="{FF2B5EF4-FFF2-40B4-BE49-F238E27FC236}">
                  <a16:creationId xmlns:a16="http://schemas.microsoft.com/office/drawing/2014/main" id="{4B882908-7D54-90B7-2AA0-9E088CD49572}"/>
                </a:ext>
              </a:extLst>
            </p:cNvPr>
            <p:cNvSpPr txBox="1"/>
            <p:nvPr/>
          </p:nvSpPr>
          <p:spPr>
            <a:xfrm>
              <a:off x="7927044" y="9138962"/>
              <a:ext cx="492443" cy="48987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24h</a:t>
              </a:r>
            </a:p>
          </p:txBody>
        </p:sp>
        <p:sp>
          <p:nvSpPr>
            <p:cNvPr id="60" name="CaixaDeTexto 59">
              <a:extLst>
                <a:ext uri="{FF2B5EF4-FFF2-40B4-BE49-F238E27FC236}">
                  <a16:creationId xmlns:a16="http://schemas.microsoft.com/office/drawing/2014/main" id="{E8B2F53E-EEB8-A5AC-AE55-AD33E56E4B83}"/>
                </a:ext>
              </a:extLst>
            </p:cNvPr>
            <p:cNvSpPr txBox="1"/>
            <p:nvPr/>
          </p:nvSpPr>
          <p:spPr>
            <a:xfrm>
              <a:off x="8320744" y="9151662"/>
              <a:ext cx="492443" cy="48987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48h</a:t>
              </a:r>
            </a:p>
          </p:txBody>
        </p:sp>
        <p:sp>
          <p:nvSpPr>
            <p:cNvPr id="61" name="CaixaDeTexto 60">
              <a:extLst>
                <a:ext uri="{FF2B5EF4-FFF2-40B4-BE49-F238E27FC236}">
                  <a16:creationId xmlns:a16="http://schemas.microsoft.com/office/drawing/2014/main" id="{2EB50E82-0802-3358-F495-BFD53E1CC5E5}"/>
                </a:ext>
              </a:extLst>
            </p:cNvPr>
            <p:cNvSpPr txBox="1"/>
            <p:nvPr/>
          </p:nvSpPr>
          <p:spPr>
            <a:xfrm>
              <a:off x="8701744" y="9164362"/>
              <a:ext cx="492443" cy="48987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pt-BR" sz="2000" b="1" dirty="0"/>
                <a:t>10d</a:t>
              </a:r>
            </a:p>
          </p:txBody>
        </p:sp>
        <p:sp>
          <p:nvSpPr>
            <p:cNvPr id="62" name="CaixaDeTexto 61">
              <a:extLst>
                <a:ext uri="{FF2B5EF4-FFF2-40B4-BE49-F238E27FC236}">
                  <a16:creationId xmlns:a16="http://schemas.microsoft.com/office/drawing/2014/main" id="{EAFE643A-73EF-F816-0133-8984EFD76E4D}"/>
                </a:ext>
              </a:extLst>
            </p:cNvPr>
            <p:cNvSpPr txBox="1"/>
            <p:nvPr/>
          </p:nvSpPr>
          <p:spPr>
            <a:xfrm>
              <a:off x="6514034" y="6978609"/>
              <a:ext cx="461665" cy="2261838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wrap="none" rtlCol="0">
              <a:spAutoFit/>
            </a:bodyPr>
            <a:lstStyle/>
            <a:p>
              <a:r>
                <a:rPr lang="en-US" b="1" dirty="0" err="1"/>
                <a:t>ThT</a:t>
              </a:r>
              <a:r>
                <a:rPr lang="en-US" b="1" dirty="0"/>
                <a:t> fluorescence (</a:t>
              </a:r>
              <a:r>
                <a:rPr lang="en-US" b="1" dirty="0" err="1"/>
                <a:t>a.u</a:t>
              </a:r>
              <a:r>
                <a:rPr lang="en-US" b="1" dirty="0"/>
                <a:t>.)</a:t>
              </a:r>
            </a:p>
          </p:txBody>
        </p:sp>
      </p:grpSp>
      <p:sp>
        <p:nvSpPr>
          <p:cNvPr id="64" name="TextBox 62">
            <a:extLst>
              <a:ext uri="{FF2B5EF4-FFF2-40B4-BE49-F238E27FC236}">
                <a16:creationId xmlns:a16="http://schemas.microsoft.com/office/drawing/2014/main" id="{593B7FA6-F40E-5F91-C81E-0AA1176632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716" y="7853397"/>
            <a:ext cx="44275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G</a:t>
            </a:r>
          </a:p>
        </p:txBody>
      </p:sp>
      <p:sp>
        <p:nvSpPr>
          <p:cNvPr id="65" name="TextBox 62">
            <a:extLst>
              <a:ext uri="{FF2B5EF4-FFF2-40B4-BE49-F238E27FC236}">
                <a16:creationId xmlns:a16="http://schemas.microsoft.com/office/drawing/2014/main" id="{B0F8EEAE-9640-974C-B21E-D6792C6A9D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0316" y="7853397"/>
            <a:ext cx="44435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H</a:t>
            </a: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BFCEBC2D-CF88-289F-D4F1-A649C8DAF512}"/>
              </a:ext>
            </a:extLst>
          </p:cNvPr>
          <p:cNvSpPr txBox="1"/>
          <p:nvPr/>
        </p:nvSpPr>
        <p:spPr>
          <a:xfrm>
            <a:off x="255514" y="369651"/>
            <a:ext cx="12221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1:</a:t>
            </a:r>
          </a:p>
        </p:txBody>
      </p:sp>
    </p:spTree>
    <p:extLst>
      <p:ext uri="{BB962C8B-B14F-4D97-AF65-F5344CB8AC3E}">
        <p14:creationId xmlns:p14="http://schemas.microsoft.com/office/powerpoint/2010/main" val="3542879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62">
            <a:extLst>
              <a:ext uri="{FF2B5EF4-FFF2-40B4-BE49-F238E27FC236}">
                <a16:creationId xmlns:a16="http://schemas.microsoft.com/office/drawing/2014/main" id="{91443587-322E-63D5-D030-857F3F3203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721" y="1872875"/>
            <a:ext cx="43313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A</a:t>
            </a: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F05C0C2E-81FF-CA0B-E2B7-AB7E2F8C2321}"/>
              </a:ext>
            </a:extLst>
          </p:cNvPr>
          <p:cNvSpPr txBox="1"/>
          <p:nvPr/>
        </p:nvSpPr>
        <p:spPr>
          <a:xfrm>
            <a:off x="255514" y="369651"/>
            <a:ext cx="12221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2:</a:t>
            </a:r>
          </a:p>
        </p:txBody>
      </p:sp>
      <p:graphicFrame>
        <p:nvGraphicFramePr>
          <p:cNvPr id="3" name="Object 3">
            <a:extLst>
              <a:ext uri="{FF2B5EF4-FFF2-40B4-BE49-F238E27FC236}">
                <a16:creationId xmlns:a16="http://schemas.microsoft.com/office/drawing/2014/main" id="{D5E293A7-AEE2-0FEA-0ADF-1CB17BF9FA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3350750"/>
              </p:ext>
            </p:extLst>
          </p:nvPr>
        </p:nvGraphicFramePr>
        <p:xfrm>
          <a:off x="260350" y="6972300"/>
          <a:ext cx="8990013" cy="4881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6272124" imgH="3406766" progId="Prism8.Document">
                  <p:embed/>
                </p:oleObj>
              </mc:Choice>
              <mc:Fallback>
                <p:oleObj name="Prism 8" r:id="rId3" imgW="6272124" imgH="3406766" progId="Prism8.Document">
                  <p:embed/>
                  <p:pic>
                    <p:nvPicPr>
                      <p:cNvPr id="3" name="Object 3">
                        <a:extLst>
                          <a:ext uri="{FF2B5EF4-FFF2-40B4-BE49-F238E27FC236}">
                            <a16:creationId xmlns:a16="http://schemas.microsoft.com/office/drawing/2014/main" id="{D5E293A7-AEE2-0FEA-0ADF-1CB17BF9FA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0350" y="6972300"/>
                        <a:ext cx="8990013" cy="4881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3">
            <a:extLst>
              <a:ext uri="{FF2B5EF4-FFF2-40B4-BE49-F238E27FC236}">
                <a16:creationId xmlns:a16="http://schemas.microsoft.com/office/drawing/2014/main" id="{9212E697-7076-D960-B030-B1B41CD675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8720022"/>
              </p:ext>
            </p:extLst>
          </p:nvPr>
        </p:nvGraphicFramePr>
        <p:xfrm>
          <a:off x="258763" y="2149475"/>
          <a:ext cx="8802687" cy="4779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6272124" imgH="3406766" progId="Prism8.Document">
                  <p:embed/>
                </p:oleObj>
              </mc:Choice>
              <mc:Fallback>
                <p:oleObj name="Prism 8" r:id="rId5" imgW="6272124" imgH="3406766" progId="Prism8.Document">
                  <p:embed/>
                  <p:pic>
                    <p:nvPicPr>
                      <p:cNvPr id="5" name="Object 3">
                        <a:extLst>
                          <a:ext uri="{FF2B5EF4-FFF2-40B4-BE49-F238E27FC236}">
                            <a16:creationId xmlns:a16="http://schemas.microsoft.com/office/drawing/2014/main" id="{9212E697-7076-D960-B030-B1B41CD67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8763" y="2149475"/>
                        <a:ext cx="8802687" cy="4779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62">
            <a:extLst>
              <a:ext uri="{FF2B5EF4-FFF2-40B4-BE49-F238E27FC236}">
                <a16:creationId xmlns:a16="http://schemas.microsoft.com/office/drawing/2014/main" id="{8B924057-9149-6AE7-A390-D6C9657762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974" y="6815939"/>
            <a:ext cx="415498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t-BR" altLang="pt-BR" b="1" dirty="0">
                <a:latin typeface="Calibri" panose="020F0502020204030204" pitchFamily="34" charset="0"/>
              </a:rPr>
              <a:t>B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F813553F-DCE2-AB96-8262-B3F4124C6FD1}"/>
              </a:ext>
            </a:extLst>
          </p:cNvPr>
          <p:cNvSpPr txBox="1"/>
          <p:nvPr/>
        </p:nvSpPr>
        <p:spPr>
          <a:xfrm>
            <a:off x="2741119" y="7176894"/>
            <a:ext cx="41453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Non-differentiated N2a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D3E16D0A-880D-AFB1-3D61-C878C66F641C}"/>
              </a:ext>
            </a:extLst>
          </p:cNvPr>
          <p:cNvSpPr txBox="1"/>
          <p:nvPr/>
        </p:nvSpPr>
        <p:spPr>
          <a:xfrm>
            <a:off x="3370586" y="2031328"/>
            <a:ext cx="334700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Differentiated N2a</a:t>
            </a:r>
          </a:p>
        </p:txBody>
      </p:sp>
    </p:spTree>
    <p:extLst>
      <p:ext uri="{BB962C8B-B14F-4D97-AF65-F5344CB8AC3E}">
        <p14:creationId xmlns:p14="http://schemas.microsoft.com/office/powerpoint/2010/main" val="3371538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F05C0C2E-81FF-CA0B-E2B7-AB7E2F8C2321}"/>
              </a:ext>
            </a:extLst>
          </p:cNvPr>
          <p:cNvSpPr txBox="1"/>
          <p:nvPr/>
        </p:nvSpPr>
        <p:spPr>
          <a:xfrm>
            <a:off x="255514" y="369651"/>
            <a:ext cx="12221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3:</a:t>
            </a:r>
          </a:p>
        </p:txBody>
      </p:sp>
      <p:grpSp>
        <p:nvGrpSpPr>
          <p:cNvPr id="21" name="Agrupar 20">
            <a:extLst>
              <a:ext uri="{FF2B5EF4-FFF2-40B4-BE49-F238E27FC236}">
                <a16:creationId xmlns:a16="http://schemas.microsoft.com/office/drawing/2014/main" id="{B1DCB615-4A18-5ACA-F15F-6F9587D9141D}"/>
              </a:ext>
            </a:extLst>
          </p:cNvPr>
          <p:cNvGrpSpPr/>
          <p:nvPr/>
        </p:nvGrpSpPr>
        <p:grpSpPr>
          <a:xfrm>
            <a:off x="194725" y="946395"/>
            <a:ext cx="8045732" cy="4407255"/>
            <a:chOff x="194725" y="946395"/>
            <a:chExt cx="8045732" cy="4407255"/>
          </a:xfrm>
        </p:grpSpPr>
        <p:sp>
          <p:nvSpPr>
            <p:cNvPr id="25" name="TextBox 22">
              <a:extLst>
                <a:ext uri="{FF2B5EF4-FFF2-40B4-BE49-F238E27FC236}">
                  <a16:creationId xmlns:a16="http://schemas.microsoft.com/office/drawing/2014/main" id="{0C3AF4F0-4C54-112A-4A38-992F7AFFDB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154" y="1653703"/>
              <a:ext cx="461665" cy="15396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vert270"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pt-BR" altLang="pt-BR" sz="1800" b="1" dirty="0">
                  <a:latin typeface="Calibri" panose="020F0502020204030204" pitchFamily="34" charset="0"/>
                </a:rPr>
                <a:t>N2a</a:t>
              </a:r>
            </a:p>
          </p:txBody>
        </p:sp>
        <p:sp>
          <p:nvSpPr>
            <p:cNvPr id="26" name="TextBox 23">
              <a:extLst>
                <a:ext uri="{FF2B5EF4-FFF2-40B4-BE49-F238E27FC236}">
                  <a16:creationId xmlns:a16="http://schemas.microsoft.com/office/drawing/2014/main" id="{58CBE26B-01C2-B98B-1EAF-0EFEEED3F0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030" y="3288963"/>
              <a:ext cx="461665" cy="20646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vert="vert270"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pt-BR" sz="1800" b="1" dirty="0">
                  <a:latin typeface="Calibri" panose="020F0502020204030204" pitchFamily="34" charset="0"/>
                </a:rPr>
                <a:t>Differentiated</a:t>
              </a:r>
              <a:r>
                <a:rPr lang="pt-BR" altLang="pt-BR" sz="1800" b="1" dirty="0">
                  <a:latin typeface="Calibri" panose="020F0502020204030204" pitchFamily="34" charset="0"/>
                </a:rPr>
                <a:t> N2a</a:t>
              </a:r>
            </a:p>
          </p:txBody>
        </p:sp>
        <p:sp>
          <p:nvSpPr>
            <p:cNvPr id="27" name="TextBox 62">
              <a:extLst>
                <a:ext uri="{FF2B5EF4-FFF2-40B4-BE49-F238E27FC236}">
                  <a16:creationId xmlns:a16="http://schemas.microsoft.com/office/drawing/2014/main" id="{91443587-322E-63D5-D030-857F3F3203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4725" y="946395"/>
              <a:ext cx="433132" cy="5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pt-BR" altLang="pt-BR" b="1" dirty="0">
                  <a:latin typeface="Calibri" panose="020F0502020204030204" pitchFamily="34" charset="0"/>
                </a:rPr>
                <a:t>A</a:t>
              </a:r>
            </a:p>
          </p:txBody>
        </p:sp>
        <p:pic>
          <p:nvPicPr>
            <p:cNvPr id="3" name="Imagem 2" descr="Fundo preto com estrelas&#10;&#10;Descrição gerada automaticamente com confiança média">
              <a:extLst>
                <a:ext uri="{FF2B5EF4-FFF2-40B4-BE49-F238E27FC236}">
                  <a16:creationId xmlns:a16="http://schemas.microsoft.com/office/drawing/2014/main" id="{47B64E81-444B-C140-2008-01D73697280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8751" y="3380787"/>
              <a:ext cx="2390625" cy="1800000"/>
            </a:xfrm>
            <a:prstGeom prst="rect">
              <a:avLst/>
            </a:prstGeom>
          </p:spPr>
        </p:pic>
        <p:pic>
          <p:nvPicPr>
            <p:cNvPr id="5" name="Imagem 4" descr="Tela de computador com fundo preto&#10;&#10;Descrição gerada automaticamente">
              <a:extLst>
                <a:ext uri="{FF2B5EF4-FFF2-40B4-BE49-F238E27FC236}">
                  <a16:creationId xmlns:a16="http://schemas.microsoft.com/office/drawing/2014/main" id="{7BD343D3-9787-8668-8EF0-78C959A2DF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2377" y="3380787"/>
              <a:ext cx="2390625" cy="1800000"/>
            </a:xfrm>
            <a:prstGeom prst="rect">
              <a:avLst/>
            </a:prstGeom>
          </p:spPr>
        </p:pic>
        <p:pic>
          <p:nvPicPr>
            <p:cNvPr id="6" name="Imagem 5" descr="Fundo preto com estrelas&#10;&#10;Descrição gerada automaticamente com confiança média">
              <a:extLst>
                <a:ext uri="{FF2B5EF4-FFF2-40B4-BE49-F238E27FC236}">
                  <a16:creationId xmlns:a16="http://schemas.microsoft.com/office/drawing/2014/main" id="{3AC8F741-06D8-FD7B-9E03-C201D0F7DFD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0564" y="3380787"/>
              <a:ext cx="2390625" cy="1800000"/>
            </a:xfrm>
            <a:prstGeom prst="rect">
              <a:avLst/>
            </a:prstGeom>
          </p:spPr>
        </p:pic>
        <p:pic>
          <p:nvPicPr>
            <p:cNvPr id="7" name="Imagem 6" descr="Tela de computador com fundo azul&#10;&#10;Descrição gerada automaticamente">
              <a:extLst>
                <a:ext uri="{FF2B5EF4-FFF2-40B4-BE49-F238E27FC236}">
                  <a16:creationId xmlns:a16="http://schemas.microsoft.com/office/drawing/2014/main" id="{7569DAFA-53A9-7E6C-682A-18DA07F46B6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3010" y="1508403"/>
              <a:ext cx="2390625" cy="1800000"/>
            </a:xfrm>
            <a:prstGeom prst="rect">
              <a:avLst/>
            </a:prstGeom>
          </p:spPr>
        </p:pic>
        <p:pic>
          <p:nvPicPr>
            <p:cNvPr id="9" name="Imagem 8" descr="Tela de computador com fundo azul&#10;&#10;Descrição gerada automaticamente com confiança média">
              <a:extLst>
                <a:ext uri="{FF2B5EF4-FFF2-40B4-BE49-F238E27FC236}">
                  <a16:creationId xmlns:a16="http://schemas.microsoft.com/office/drawing/2014/main" id="{196931AD-3E14-9EEF-47F2-8F6F1645AC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9832" y="1505279"/>
              <a:ext cx="2390625" cy="1800000"/>
            </a:xfrm>
            <a:prstGeom prst="rect">
              <a:avLst/>
            </a:prstGeom>
          </p:spPr>
        </p:pic>
        <p:pic>
          <p:nvPicPr>
            <p:cNvPr id="10" name="Imagem 9" descr="Imagem em preto e verde&#10;&#10;Descrição gerada automaticamente com confiança média">
              <a:extLst>
                <a:ext uri="{FF2B5EF4-FFF2-40B4-BE49-F238E27FC236}">
                  <a16:creationId xmlns:a16="http://schemas.microsoft.com/office/drawing/2014/main" id="{88AD3799-9F1B-1D13-97CB-07482B60DA5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1421" y="1508403"/>
              <a:ext cx="2390625" cy="1800000"/>
            </a:xfrm>
            <a:prstGeom prst="rect">
              <a:avLst/>
            </a:prstGeom>
          </p:spPr>
        </p:pic>
        <p:sp>
          <p:nvSpPr>
            <p:cNvPr id="15" name="CaixaDeTexto 14">
              <a:extLst>
                <a:ext uri="{FF2B5EF4-FFF2-40B4-BE49-F238E27FC236}">
                  <a16:creationId xmlns:a16="http://schemas.microsoft.com/office/drawing/2014/main" id="{F9BFBA75-1EF7-D960-7A35-8DD4C51FC735}"/>
                </a:ext>
              </a:extLst>
            </p:cNvPr>
            <p:cNvSpPr txBox="1"/>
            <p:nvPr/>
          </p:nvSpPr>
          <p:spPr>
            <a:xfrm>
              <a:off x="1754642" y="1135372"/>
              <a:ext cx="8025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DAPI</a:t>
              </a:r>
            </a:p>
          </p:txBody>
        </p:sp>
        <p:sp>
          <p:nvSpPr>
            <p:cNvPr id="18" name="CaixaDeTexto 17">
              <a:extLst>
                <a:ext uri="{FF2B5EF4-FFF2-40B4-BE49-F238E27FC236}">
                  <a16:creationId xmlns:a16="http://schemas.microsoft.com/office/drawing/2014/main" id="{7AE63893-2622-6C13-21FE-ED8C9DFEFD4E}"/>
                </a:ext>
              </a:extLst>
            </p:cNvPr>
            <p:cNvSpPr txBox="1"/>
            <p:nvPr/>
          </p:nvSpPr>
          <p:spPr>
            <a:xfrm>
              <a:off x="4383542" y="1135372"/>
              <a:ext cx="5309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TH</a:t>
              </a:r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758C8748-10AA-99C7-74A2-80CA7AF39CF6}"/>
                </a:ext>
              </a:extLst>
            </p:cNvPr>
            <p:cNvSpPr txBox="1"/>
            <p:nvPr/>
          </p:nvSpPr>
          <p:spPr>
            <a:xfrm>
              <a:off x="6567942" y="1135372"/>
              <a:ext cx="112158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MERG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950362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a 5">
            <a:extLst>
              <a:ext uri="{FF2B5EF4-FFF2-40B4-BE49-F238E27FC236}">
                <a16:creationId xmlns:a16="http://schemas.microsoft.com/office/drawing/2014/main" id="{7E3D9EB9-540E-AB6C-34F0-E6A76B3856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4981021"/>
              </p:ext>
            </p:extLst>
          </p:nvPr>
        </p:nvGraphicFramePr>
        <p:xfrm>
          <a:off x="248092" y="1835888"/>
          <a:ext cx="9010800" cy="964576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90000">
                  <a:extLst>
                    <a:ext uri="{9D8B030D-6E8A-4147-A177-3AD203B41FA5}">
                      <a16:colId xmlns:a16="http://schemas.microsoft.com/office/drawing/2014/main" val="3014103896"/>
                    </a:ext>
                  </a:extLst>
                </a:gridCol>
                <a:gridCol w="2656800">
                  <a:extLst>
                    <a:ext uri="{9D8B030D-6E8A-4147-A177-3AD203B41FA5}">
                      <a16:colId xmlns:a16="http://schemas.microsoft.com/office/drawing/2014/main" val="4045880467"/>
                    </a:ext>
                  </a:extLst>
                </a:gridCol>
                <a:gridCol w="1710000">
                  <a:extLst>
                    <a:ext uri="{9D8B030D-6E8A-4147-A177-3AD203B41FA5}">
                      <a16:colId xmlns:a16="http://schemas.microsoft.com/office/drawing/2014/main" val="828361511"/>
                    </a:ext>
                  </a:extLst>
                </a:gridCol>
                <a:gridCol w="1710000">
                  <a:extLst>
                    <a:ext uri="{9D8B030D-6E8A-4147-A177-3AD203B41FA5}">
                      <a16:colId xmlns:a16="http://schemas.microsoft.com/office/drawing/2014/main" val="1091641025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233448240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3315069937"/>
                    </a:ext>
                  </a:extLst>
                </a:gridCol>
              </a:tblGrid>
              <a:tr h="1359295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Abbreviation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Nam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FORWARD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REVERSE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Up or Down regulation by α-syn-O (2-folds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VIVIT </a:t>
                      </a:r>
                      <a:r>
                        <a:rPr lang="pt-BR" sz="1400" b="1" u="none" strike="noStrike" dirty="0" err="1">
                          <a:effectLst/>
                        </a:rPr>
                        <a:t>restored</a:t>
                      </a:r>
                      <a:r>
                        <a:rPr lang="pt-BR" sz="1400" b="1" u="none" strike="noStrike" dirty="0">
                          <a:effectLst/>
                        </a:rPr>
                        <a:t> normal </a:t>
                      </a:r>
                      <a:r>
                        <a:rPr lang="pt-BR" sz="1400" b="1" u="none" strike="noStrike" dirty="0" err="1">
                          <a:effectLst/>
                        </a:rPr>
                        <a:t>phenotyp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extLst>
                  <a:ext uri="{0D108BD9-81ED-4DB2-BD59-A6C34878D82A}">
                    <a16:rowId xmlns:a16="http://schemas.microsoft.com/office/drawing/2014/main" val="246955490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ctr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RP2 actin-related protein 2 homolog (yeast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CTCTGTCCCTTTTG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AGAAAGCAAAAATT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6990272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ctr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P3 actin-related protein 3 homolog (yeast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CGAGATCTTTTTCC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CCCTGAACATGGTT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5161784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ctivity regulated cytoskeletal-associated prote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AGAATGACACCAG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CACCTCCTCTCTGT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330195105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hgef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ho/rac guanine nucleotide exchange factor (GEF) 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CCTGTAACAAGAGCA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GGGAGACAGACTG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17803998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hgef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ho guanine nucleotide exchange factor (GEF) 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GGGAAAACTGACTG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CACCTTGATGCTGT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96806746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Arhgef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ac/Cdc42 guanine nucleotide exchange factor (GEF) 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AGCTTTGTGCTTTG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AAAGGGCTGTTGGG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00550069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d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CL2-associated agonist of cell deat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CTTTCGAGGCCTTA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CAGTTATGACAGG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53302348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ax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associated X prote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GCAAACTGGTGCTCA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GGTCACTGTCTGCCAT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15956324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bc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 binding component 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GGTCTGTGAAGAG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GAGCACAGGATTC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7356601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B </a:t>
                      </a:r>
                      <a:r>
                        <a:rPr lang="pt-BR" sz="1000" u="none" strike="noStrike" dirty="0" err="1">
                          <a:effectLst/>
                        </a:rPr>
                        <a:t>cell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leukemia</a:t>
                      </a:r>
                      <a:r>
                        <a:rPr lang="pt-BR" sz="1000" u="none" strike="noStrike" dirty="0">
                          <a:effectLst/>
                        </a:rPr>
                        <a:t>/</a:t>
                      </a:r>
                      <a:r>
                        <a:rPr lang="pt-BR" sz="1000" u="none" strike="noStrike" dirty="0" err="1">
                          <a:effectLst/>
                        </a:rPr>
                        <a:t>lymphoma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CTTCTCTCGTCGCTAC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CTCAAAGAAGGCCAC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03442200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A1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B cell leukemia/lymphoma 2 related protein A1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AACTGGGGAAGGATTGTG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CCAGATCTGTCCTGTCAT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26015710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BCL2-like 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ATCCCAGCTTCACATAAC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CAATCCGACTCACCAAT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9054429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GCAACAGCCATCTT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CACAAACCCAGAACTC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21159619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1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11 (apoptosis facilitator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GTTAGGGGCTGGCTC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CCAAGAAAGAGCACC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35934906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L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2-like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AACCAGGGTCAGGT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TGGTTTTCCCTGACA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606542867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cl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B </a:t>
                      </a:r>
                      <a:r>
                        <a:rPr lang="pt-BR" sz="1000" u="none" strike="noStrike" dirty="0" err="1">
                          <a:effectLst/>
                        </a:rPr>
                        <a:t>cell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leukemia</a:t>
                      </a:r>
                      <a:r>
                        <a:rPr lang="pt-BR" sz="1000" u="none" strike="noStrike" dirty="0">
                          <a:effectLst/>
                        </a:rPr>
                        <a:t>/</a:t>
                      </a:r>
                      <a:r>
                        <a:rPr lang="pt-BR" sz="1000" u="none" strike="noStrike" dirty="0" err="1">
                          <a:effectLst/>
                        </a:rPr>
                        <a:t>lymphoma</a:t>
                      </a:r>
                      <a:r>
                        <a:rPr lang="pt-BR" sz="1000" u="none" strike="noStrike" dirty="0">
                          <a:effectLst/>
                        </a:rPr>
                        <a:t> 6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TGAGGGAAGGCAAT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CTGTTCAGGAACTC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61300051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dn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brain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derived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neurotrophic</a:t>
                      </a:r>
                      <a:r>
                        <a:rPr lang="pt-BR" sz="1000" u="none" strike="noStrike" dirty="0">
                          <a:effectLst/>
                        </a:rPr>
                        <a:t> fator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TGCAGAAAAGCAAC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CAAAAAGTTCCCAG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6108706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d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BH3 interacting domain death agonis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GCTACGGAATGCAA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ACCCAGGGAAAGAGGA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48344304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k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BCL2-interacting killer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GGTCTGTGAAGAGCA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GAGCACAGGATTC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634935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rc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baculoviral</a:t>
                      </a:r>
                      <a:r>
                        <a:rPr lang="pt-BR" sz="1000" u="none" strike="noStrike" dirty="0">
                          <a:effectLst/>
                        </a:rPr>
                        <a:t> IAP </a:t>
                      </a:r>
                      <a:r>
                        <a:rPr lang="pt-BR" sz="1000" u="none" strike="noStrike" dirty="0" err="1">
                          <a:effectLst/>
                        </a:rPr>
                        <a:t>repeat-containing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CTTGCTGTATGTCC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TGCACGCCTTTAAAA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71437102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rc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baculoviral</a:t>
                      </a:r>
                      <a:r>
                        <a:rPr lang="pt-BR" sz="1000" u="none" strike="noStrike" dirty="0">
                          <a:effectLst/>
                        </a:rPr>
                        <a:t> IAP </a:t>
                      </a:r>
                      <a:r>
                        <a:rPr lang="pt-BR" sz="1000" u="none" strike="noStrike" dirty="0" err="1">
                          <a:effectLst/>
                        </a:rPr>
                        <a:t>repeat-containing</a:t>
                      </a:r>
                      <a:r>
                        <a:rPr lang="pt-BR" sz="1000" u="none" strike="noStrike" dirty="0">
                          <a:effectLst/>
                        </a:rPr>
                        <a:t> 3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CCAACATTTGACG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GCTGCAGTGTTTCCT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04331640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irc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baculoviral</a:t>
                      </a:r>
                      <a:r>
                        <a:rPr lang="pt-BR" sz="1000" u="none" strike="noStrike" dirty="0">
                          <a:effectLst/>
                        </a:rPr>
                        <a:t> IAP </a:t>
                      </a:r>
                      <a:r>
                        <a:rPr lang="pt-BR" sz="1000" u="none" strike="noStrike" dirty="0" err="1">
                          <a:effectLst/>
                        </a:rPr>
                        <a:t>repeat-containing</a:t>
                      </a:r>
                      <a:r>
                        <a:rPr lang="pt-BR" sz="1000" u="none" strike="noStrike" dirty="0">
                          <a:effectLst/>
                        </a:rPr>
                        <a:t> 5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TTTTGTGGCTTTGCTC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ATTAGCAGCCCTGT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5303709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m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BCL2 </a:t>
                      </a:r>
                      <a:r>
                        <a:rPr lang="pt-BR" sz="1000" u="none" strike="noStrike" dirty="0" err="1">
                          <a:effectLst/>
                        </a:rPr>
                        <a:t>modifying</a:t>
                      </a:r>
                      <a:r>
                        <a:rPr lang="pt-BR" sz="1000" u="none" strike="noStrike" dirty="0">
                          <a:effectLst/>
                        </a:rPr>
                        <a:t> fator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CTTCTGGTATGTGC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AAACTCTGGGCTCAGT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4992808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mp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bon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morphogenetic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rotein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CACACTTGCTGTCTG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CTCACGGATTGGA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097517580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Bmp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bon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morphogenetic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rotein</a:t>
                      </a:r>
                      <a:r>
                        <a:rPr lang="pt-BR" sz="1000" u="none" strike="noStrike" dirty="0">
                          <a:effectLst/>
                        </a:rPr>
                        <a:t> 4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GAGCTCTGCTTTTCG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TGTCCAGTAGTCG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472238290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lm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almodulin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GCAGAACTGCAGGA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ACTTCTCGCCAAGG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55144118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alm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almodulin</a:t>
                      </a:r>
                      <a:r>
                        <a:rPr lang="pt-BR" sz="1000" u="none" strike="noStrike" dirty="0">
                          <a:effectLst/>
                        </a:rPr>
                        <a:t> 3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AGCTGACTGAGGA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CATCATGGTCAAGAA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4018302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cl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hemokine</a:t>
                      </a:r>
                      <a:r>
                        <a:rPr lang="pt-BR" sz="1000" u="none" strike="noStrike" dirty="0">
                          <a:effectLst/>
                        </a:rPr>
                        <a:t> (C-C </a:t>
                      </a:r>
                      <a:r>
                        <a:rPr lang="pt-BR" sz="1000" u="none" strike="noStrike" dirty="0" err="1">
                          <a:effectLst/>
                        </a:rPr>
                        <a:t>motif</a:t>
                      </a:r>
                      <a:r>
                        <a:rPr lang="pt-BR" sz="1000" u="none" strike="noStrike" dirty="0">
                          <a:effectLst/>
                        </a:rPr>
                        <a:t>) </a:t>
                      </a:r>
                      <a:r>
                        <a:rPr lang="pt-BR" sz="1000" u="none" strike="noStrike" dirty="0" err="1">
                          <a:effectLst/>
                        </a:rPr>
                        <a:t>ligand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TTTTGTCACCAAGC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TCAACTTCACAT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877238631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dh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adherin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TGTGATGACGGTCAC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GGCCATAAGTGGGA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3364942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dkn1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yclin-dependent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kinas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inhibitor</a:t>
                      </a:r>
                      <a:r>
                        <a:rPr lang="pt-BR" sz="1000" u="none" strike="noStrike" dirty="0">
                          <a:effectLst/>
                        </a:rPr>
                        <a:t> 1B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CGTTTCTTCATTGCCT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CAAAACATGCCACTT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93427775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fl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ofilin</a:t>
                      </a:r>
                      <a:r>
                        <a:rPr lang="pt-BR" sz="1000" u="none" strike="noStrike" dirty="0">
                          <a:effectLst/>
                        </a:rPr>
                        <a:t> 1, non-</a:t>
                      </a:r>
                      <a:r>
                        <a:rPr lang="pt-BR" sz="1000" u="none" strike="noStrike" dirty="0" err="1">
                          <a:effectLst/>
                        </a:rPr>
                        <a:t>muscle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CTCCTACTAAACGGA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CCTCACTCAGGCAAA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74083395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Creb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cAMP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responsiv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element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binding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rotein</a:t>
                      </a:r>
                      <a:r>
                        <a:rPr lang="pt-BR" sz="1000" u="none" strike="noStrike" dirty="0">
                          <a:effectLst/>
                        </a:rPr>
                        <a:t> 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GCTGTGACTTGGCA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TTCTGTTTGGGACCT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97627601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st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Destrin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GTCCAGGAAAGAAGA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CACAGGGGATCCT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53237732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Egr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early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growth</a:t>
                      </a:r>
                      <a:r>
                        <a:rPr lang="pt-BR" sz="1000" u="none" strike="noStrike" dirty="0">
                          <a:effectLst/>
                        </a:rPr>
                        <a:t> response 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GCAGTCCCATCTACTC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CCCTGTTGTTGTGGA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049334196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Fasl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Fas</a:t>
                      </a:r>
                      <a:r>
                        <a:rPr lang="en-US" sz="1000" u="none" strike="noStrike" dirty="0">
                          <a:effectLst/>
                        </a:rPr>
                        <a:t> ligand (TNF superfamily, member 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GGAGTGGTCCTTAA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GTAGACCCACCCTGGA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105226322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Fgf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fibroblast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growth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factor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GCTGGCTTCTAAG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ATGGCCTTCTGTCCAG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308286035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ria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glutamate</a:t>
                      </a:r>
                      <a:r>
                        <a:rPr lang="pt-BR" sz="1000" u="none" strike="noStrike" dirty="0">
                          <a:effectLst/>
                        </a:rPr>
                        <a:t> receptor, </a:t>
                      </a:r>
                      <a:r>
                        <a:rPr lang="pt-BR" sz="1000" u="none" strike="noStrike" dirty="0" err="1">
                          <a:effectLst/>
                        </a:rPr>
                        <a:t>ionotropic</a:t>
                      </a:r>
                      <a:r>
                        <a:rPr lang="pt-BR" sz="1000" u="none" strike="noStrike" dirty="0">
                          <a:effectLst/>
                        </a:rPr>
                        <a:t>, AMPA1 (alpha 1)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AAAGGGGAATGTGGAA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ACGGGATTTGTAGCA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04159465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ria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glutamate</a:t>
                      </a:r>
                      <a:r>
                        <a:rPr lang="pt-BR" sz="1000" u="none" strike="noStrike" dirty="0">
                          <a:effectLst/>
                        </a:rPr>
                        <a:t> receptor, </a:t>
                      </a:r>
                      <a:r>
                        <a:rPr lang="pt-BR" sz="1000" u="none" strike="noStrike" dirty="0" err="1">
                          <a:effectLst/>
                        </a:rPr>
                        <a:t>ionotropic</a:t>
                      </a:r>
                      <a:r>
                        <a:rPr lang="pt-BR" sz="1000" u="none" strike="noStrike" dirty="0">
                          <a:effectLst/>
                        </a:rPr>
                        <a:t>, AMPA2 (alpha 2)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GAAAGGGATAAAG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GTGTGCTCCAGGGTAT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215281071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rin2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glutamate</a:t>
                      </a:r>
                      <a:r>
                        <a:rPr lang="pt-BR" sz="1000" u="none" strike="noStrike" dirty="0">
                          <a:effectLst/>
                        </a:rPr>
                        <a:t> receptor, </a:t>
                      </a:r>
                      <a:r>
                        <a:rPr lang="pt-BR" sz="1000" u="none" strike="noStrike" dirty="0" err="1">
                          <a:effectLst/>
                        </a:rPr>
                        <a:t>ionotropic</a:t>
                      </a:r>
                      <a:r>
                        <a:rPr lang="pt-BR" sz="1000" u="none" strike="noStrike" dirty="0">
                          <a:effectLst/>
                        </a:rPr>
                        <a:t>, NMDA2B (</a:t>
                      </a:r>
                      <a:r>
                        <a:rPr lang="pt-BR" sz="1000" u="none" strike="noStrike" dirty="0" err="1">
                          <a:effectLst/>
                        </a:rPr>
                        <a:t>epsilon</a:t>
                      </a:r>
                      <a:r>
                        <a:rPr lang="pt-BR" sz="1000" u="none" strike="noStrike" dirty="0">
                          <a:effectLst/>
                        </a:rPr>
                        <a:t> 2)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GCAGCACTATTGAGA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CCATGTGTAGCCGTAGC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374271344"/>
                  </a:ext>
                </a:extLst>
              </a:tr>
              <a:tr h="32814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Hrk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harakiri</a:t>
                      </a:r>
                      <a:r>
                        <a:rPr lang="en-US" sz="1000" u="none" strike="noStrike" dirty="0">
                          <a:effectLst/>
                        </a:rPr>
                        <a:t>, BCL2 interacting protein (contains only BH3 domain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GCTCTGGGAAGTCTG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AAAGAGCACAAGG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789862109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l1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nterleukin 1 be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AACTGGTACATCAG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TGCTCATTCACGAAAA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827173584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l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nterleukin 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ACCCCAATTTCCAATG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ACAGTGAGGAATGTC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436820908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tpr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inositol 1,4,5-trisphosphate receptor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CTCCTGGAGAAGC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CGCCTTCAAAC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3823101113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Kalr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Kalirin, RhoGEF kinase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TTCATACAGGAGGGCAC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GCTTCAGGAAGGACTTAGG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135613300"/>
                  </a:ext>
                </a:extLst>
              </a:tr>
              <a:tr h="171394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Map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Microtubule-associated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rotein</a:t>
                      </a:r>
                      <a:r>
                        <a:rPr lang="pt-BR" sz="1000" u="none" strike="noStrike" dirty="0">
                          <a:effectLst/>
                        </a:rPr>
                        <a:t> 2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CCTTCTTTCCCTCGTTTC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CTTGCCAGCAGTCACAA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90" marR="5590" marT="5590" marB="0" anchor="b"/>
                </a:tc>
                <a:extLst>
                  <a:ext uri="{0D108BD9-81ED-4DB2-BD59-A6C34878D82A}">
                    <a16:rowId xmlns:a16="http://schemas.microsoft.com/office/drawing/2014/main" val="1281428052"/>
                  </a:ext>
                </a:extLst>
              </a:tr>
            </a:tbl>
          </a:graphicData>
        </a:graphic>
      </p:graphicFrame>
      <p:sp>
        <p:nvSpPr>
          <p:cNvPr id="2" name="CaixaDeTexto 1">
            <a:extLst>
              <a:ext uri="{FF2B5EF4-FFF2-40B4-BE49-F238E27FC236}">
                <a16:creationId xmlns:a16="http://schemas.microsoft.com/office/drawing/2014/main" id="{E447F427-6343-52FD-E9F5-8E0B5495682C}"/>
              </a:ext>
            </a:extLst>
          </p:cNvPr>
          <p:cNvSpPr txBox="1"/>
          <p:nvPr/>
        </p:nvSpPr>
        <p:spPr>
          <a:xfrm>
            <a:off x="255514" y="369651"/>
            <a:ext cx="11286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Table S1:</a:t>
            </a:r>
          </a:p>
        </p:txBody>
      </p:sp>
    </p:spTree>
    <p:extLst>
      <p:ext uri="{BB962C8B-B14F-4D97-AF65-F5344CB8AC3E}">
        <p14:creationId xmlns:p14="http://schemas.microsoft.com/office/powerpoint/2010/main" val="35905621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a 6">
            <a:extLst>
              <a:ext uri="{FF2B5EF4-FFF2-40B4-BE49-F238E27FC236}">
                <a16:creationId xmlns:a16="http://schemas.microsoft.com/office/drawing/2014/main" id="{ACF30C1B-00FD-58AF-313E-4513B5C154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7890400"/>
              </p:ext>
            </p:extLst>
          </p:nvPr>
        </p:nvGraphicFramePr>
        <p:xfrm>
          <a:off x="170122" y="1070348"/>
          <a:ext cx="9005720" cy="10098056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88541">
                  <a:extLst>
                    <a:ext uri="{9D8B030D-6E8A-4147-A177-3AD203B41FA5}">
                      <a16:colId xmlns:a16="http://schemas.microsoft.com/office/drawing/2014/main" val="1170602937"/>
                    </a:ext>
                  </a:extLst>
                </a:gridCol>
                <a:gridCol w="2654881">
                  <a:extLst>
                    <a:ext uri="{9D8B030D-6E8A-4147-A177-3AD203B41FA5}">
                      <a16:colId xmlns:a16="http://schemas.microsoft.com/office/drawing/2014/main" val="1935969309"/>
                    </a:ext>
                  </a:extLst>
                </a:gridCol>
                <a:gridCol w="1708298">
                  <a:extLst>
                    <a:ext uri="{9D8B030D-6E8A-4147-A177-3AD203B41FA5}">
                      <a16:colId xmlns:a16="http://schemas.microsoft.com/office/drawing/2014/main" val="3174978292"/>
                    </a:ext>
                  </a:extLst>
                </a:gridCol>
                <a:gridCol w="1710000">
                  <a:extLst>
                    <a:ext uri="{9D8B030D-6E8A-4147-A177-3AD203B41FA5}">
                      <a16:colId xmlns:a16="http://schemas.microsoft.com/office/drawing/2014/main" val="351668507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3969231845"/>
                    </a:ext>
                  </a:extLst>
                </a:gridCol>
                <a:gridCol w="972000">
                  <a:extLst>
                    <a:ext uri="{9D8B030D-6E8A-4147-A177-3AD203B41FA5}">
                      <a16:colId xmlns:a16="http://schemas.microsoft.com/office/drawing/2014/main" val="1547073410"/>
                    </a:ext>
                  </a:extLst>
                </a:gridCol>
              </a:tblGrid>
              <a:tr h="1366782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Abbreviation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Nam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FORWARD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REVERSE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</a:rPr>
                        <a:t>Up or Down regulation by α-syn-O (2-folds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VIVIT </a:t>
                      </a:r>
                      <a:r>
                        <a:rPr lang="pt-BR" sz="1400" b="1" u="none" strike="noStrike" dirty="0" err="1">
                          <a:effectLst/>
                        </a:rPr>
                        <a:t>restored</a:t>
                      </a:r>
                      <a:r>
                        <a:rPr lang="pt-BR" sz="1400" b="1" u="none" strike="noStrike" dirty="0">
                          <a:effectLst/>
                        </a:rPr>
                        <a:t> normal </a:t>
                      </a:r>
                      <a:r>
                        <a:rPr lang="pt-BR" sz="1400" b="1" u="none" strike="noStrike" dirty="0" err="1">
                          <a:effectLst/>
                        </a:rPr>
                        <a:t>phenotyp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extLst>
                  <a:ext uri="{0D108BD9-81ED-4DB2-BD59-A6C34878D82A}">
                    <a16:rowId xmlns:a16="http://schemas.microsoft.com/office/drawing/2014/main" val="142955708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ap2K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itogen-activated protein kinase kinase 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AAGAGGCAGTCTGTT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CTTCTTTTCGTTTT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98052947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cl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eloid cell leukemia sequence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GACTCTTAAAGCTC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GCTGAGAGGGAAC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4315448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yh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osin, heavy polypeptide 10, non-musc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ACTTGAGTGAGGAG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TTGAACCTTTTCGC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28821829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yo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myosin V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CTGCACTAGATTCTTC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TTCCAAGGTGCAGGA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40703361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g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gen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TGGGAATTTCACCT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AAATTTCCACGCTTG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39119098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g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rve growth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GCTCACCTCAGTGTCTG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TAGTCCAGTGGGCTT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217996437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gf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rve growth factor receptor (TNFR superfamily, member 16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AAGCTGCTCAATGGTG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TGTCAGCTCTCTGGA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39899930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lgn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lig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CTCCCTGGTCTGACA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GTAAGGGGACCATCT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4905733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s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itric oxide synthase 1, neuronal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CACACCTGGAGACCAC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ACCTGGGACCCTGTCT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72423972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s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itric oxide synthase 2, inducib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GTGCGAAGTGTCA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CCTGGAACAGCACTC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61985182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r4A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uclear receptor subfamily 4, group A, member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AAGCGCCAAGTACAT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CTTGGGTTTTGAAGGT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72375463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rg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egul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GGTGAAGGACCTGTC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CTTGGTTTTGCAGTAG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89895129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rg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eurogran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GCCCAAATACTCTCAA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GCAGGTATGGGATAGG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87588098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GAGGTGGCCATTAAA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TCCAGCCAAGTATTC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06118917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TTGTGGCTTGAGGAA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TTGGCTTGTCAAAGGCT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048949352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6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CCACAGAGAGCCTCA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CCAGCATGTGTTAG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97322597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ak7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21 protein (Cdc42/Rac)-activated kinase 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CAAGAACTCCTTGGA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TTTCCTCATGTTCTC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430421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fn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rofil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GAAGACCTTCGTTAGC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CAGCAGGACTAGCGT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16711160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maip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horbol-12-myristate-13-acetate-induced prote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TCGTGGAGCTAGGG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TTGCTCTGCAGTTG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NO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9854557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ml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romyelocytic leukemi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AAAGAAGGTGTGGCCTC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CTGGTATAGCGGTC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22133797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te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hosphatase and tensin homolo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AAGGATCTCCTCC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GCGTTCTGCCTAATC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46537905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ab3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AB3A, member RAS oncogene family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AAGGAGTCCTCAGAC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CTTGTCGTTGCGGTAGA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82876612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gs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egulator of G-protein signaling 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GTTGGCTTGTGAAG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CCCTCTTCTGAGCTG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41530484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he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as homolog enriched in bra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AGATGCCTCAGTCC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GCTGTGTCTACAAGCT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69764484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Rock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ho-associated coiled-coil containing protein kinase 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AAGCAAGTCAGACCT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TCTGCTTGTGACTTGG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50877209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ap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somal-associated protein 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GCTCTGAATCTCTCCA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GCGTAGTTGTTGC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4015195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c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uclein, alph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ATTGGGGAAAACAGGA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ACTGTTGTCACTCCAT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401530149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cai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uclein, alpha interacting protein (synphilin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GAAGCCACTCAGTCC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ATTTGTTCTCCGGATTC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55137692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ncb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uclein, be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TCTACCTTTTCCCCCA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TACATCCGAGCAGAC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2743782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r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erum response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GATAGAGCCTGGGCAAG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ACGGATATACCACACGCAC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58909546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sin 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ATGCTCAGCAGCACAACA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CCAGTTACCCGACACTGA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6204289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sin I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CCTCTGTTCCTTTGTG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TGCCAGGAGTCCTACGT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15671732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gap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ic Ras GTPase activating protein 1 homolog (rat)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ATGCACCGAACCCAAT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CCAAGTGGTATTCATGCT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1282614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j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jan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TGGAAGTTTGCGTGTTTC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TCTGTGAGCGTCTGGTTC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998639014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po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pod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CAAGATGGAAATGTTG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TCCCATCTGGAAGGAACT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4932136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p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physi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GTGGGTCGATGTGAC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TGGCTGACTGGTCCTCTC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998354733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t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synaptotagmin I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TCCAACCCCTACGTCA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TTTCCCAATCACACAGTGG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82538578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tyrosin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hydroxylase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TCAGAAGAGCCGTCTCA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AATACCACAGCCTCCAATG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3113308877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nf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umor necrosis factor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CACTCTGACCCCTTTAC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TTGAGTCCTTGATGGTGG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406053535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nfrsf2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mor necrosis factor receptor superfamily, member 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CACCACAGACACATTCT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GAGCTCTTTCGGATACTG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182328806"/>
                  </a:ext>
                </a:extLst>
              </a:tr>
              <a:tr h="329885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nfsf10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mor necrosis factor (ligand) superfamily, member 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TTGGGAAGTCAGACCTGG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CATCCGTCTTTGAGAAGC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701609150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rp5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ransformation related protein 53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GCTTTGAGGTTCGTGTTTG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GAACATCTCGAAGCGTT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412004376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Tubb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beta 4A class IV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AGCCTCCAAGTCCTCTC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TCCTCGTCCTTCAGCACT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DOWN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YES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757535732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amp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esicle-associated membrane protein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ATGTCTGCTCCAGCTCAA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CAAGACCTTGTCCACATT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2999195011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amp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vesicle-associated membrane protein 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TGAGGTTCCCATCACCT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TGGGGTTTGCTTTTGTT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838779355"/>
                  </a:ext>
                </a:extLst>
              </a:tr>
              <a:tr h="169778"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Xiap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X-</a:t>
                      </a:r>
                      <a:r>
                        <a:rPr lang="pt-BR" sz="1000" u="none" strike="noStrike" dirty="0" err="1">
                          <a:effectLst/>
                        </a:rPr>
                        <a:t>linked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inhibitor</a:t>
                      </a:r>
                      <a:r>
                        <a:rPr lang="pt-BR" sz="1000" u="none" strike="noStrike" dirty="0">
                          <a:effectLst/>
                        </a:rPr>
                        <a:t> of </a:t>
                      </a:r>
                      <a:r>
                        <a:rPr lang="pt-BR" sz="1000" u="none" strike="noStrike" dirty="0" err="1">
                          <a:effectLst/>
                        </a:rPr>
                        <a:t>apoptosis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TGGACATCTGGTCACTTG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TTAAAGTTCGCTCCCATC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DOWN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NO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07" marR="5507" marT="5507" marB="0" anchor="b"/>
                </a:tc>
                <a:extLst>
                  <a:ext uri="{0D108BD9-81ED-4DB2-BD59-A6C34878D82A}">
                    <a16:rowId xmlns:a16="http://schemas.microsoft.com/office/drawing/2014/main" val="14327172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215065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3">
            <a:extLst>
              <a:ext uri="{FF2B5EF4-FFF2-40B4-BE49-F238E27FC236}">
                <a16:creationId xmlns:a16="http://schemas.microsoft.com/office/drawing/2014/main" id="{F58BAB07-0E30-02E7-C190-1FE7A26AEA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1273316"/>
              </p:ext>
            </p:extLst>
          </p:nvPr>
        </p:nvGraphicFramePr>
        <p:xfrm>
          <a:off x="235098" y="831666"/>
          <a:ext cx="8823842" cy="180520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601626">
                  <a:extLst>
                    <a:ext uri="{9D8B030D-6E8A-4147-A177-3AD203B41FA5}">
                      <a16:colId xmlns:a16="http://schemas.microsoft.com/office/drawing/2014/main" val="4058851932"/>
                    </a:ext>
                  </a:extLst>
                </a:gridCol>
                <a:gridCol w="1002710">
                  <a:extLst>
                    <a:ext uri="{9D8B030D-6E8A-4147-A177-3AD203B41FA5}">
                      <a16:colId xmlns:a16="http://schemas.microsoft.com/office/drawing/2014/main" val="659115201"/>
                    </a:ext>
                  </a:extLst>
                </a:gridCol>
                <a:gridCol w="3572152">
                  <a:extLst>
                    <a:ext uri="{9D8B030D-6E8A-4147-A177-3AD203B41FA5}">
                      <a16:colId xmlns:a16="http://schemas.microsoft.com/office/drawing/2014/main" val="1351255742"/>
                    </a:ext>
                  </a:extLst>
                </a:gridCol>
                <a:gridCol w="1867546">
                  <a:extLst>
                    <a:ext uri="{9D8B030D-6E8A-4147-A177-3AD203B41FA5}">
                      <a16:colId xmlns:a16="http://schemas.microsoft.com/office/drawing/2014/main" val="3497777410"/>
                    </a:ext>
                  </a:extLst>
                </a:gridCol>
                <a:gridCol w="1779808">
                  <a:extLst>
                    <a:ext uri="{9D8B030D-6E8A-4147-A177-3AD203B41FA5}">
                      <a16:colId xmlns:a16="http://schemas.microsoft.com/office/drawing/2014/main" val="1088816904"/>
                    </a:ext>
                  </a:extLst>
                </a:gridCol>
              </a:tblGrid>
              <a:tr h="535516">
                <a:tc>
                  <a:txBody>
                    <a:bodyPr/>
                    <a:lstStyle/>
                    <a:p>
                      <a:pPr algn="l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Abbreviation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Gene </a:t>
                      </a:r>
                      <a:r>
                        <a:rPr lang="pt-BR" sz="1400" b="1" u="none" strike="noStrike" dirty="0" err="1">
                          <a:effectLst/>
                        </a:rPr>
                        <a:t>Name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FORWARD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>
                          <a:effectLst/>
                        </a:rPr>
                        <a:t>REVERSE PRIMER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3577795510"/>
                  </a:ext>
                </a:extLst>
              </a:tr>
              <a:tr h="250483">
                <a:tc>
                  <a:txBody>
                    <a:bodyPr/>
                    <a:lstStyle/>
                    <a:p>
                      <a:pPr algn="ctr" fontAlgn="b"/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Mvpa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enomic DN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GAGCCCAGTGTAGAAGAGCA 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 AGCCAGCGAACCATATCCTGA 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4213274765"/>
                  </a:ext>
                </a:extLst>
              </a:tr>
              <a:tr h="267758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pt-BR" sz="1400" b="1" u="none" strike="noStrike" dirty="0" err="1">
                          <a:effectLst/>
                        </a:rPr>
                        <a:t>Constitutive</a:t>
                      </a:r>
                      <a:r>
                        <a:rPr lang="pt-BR" sz="1400" b="1" u="none" strike="noStrike" dirty="0">
                          <a:effectLst/>
                        </a:rPr>
                        <a:t> Genes</a:t>
                      </a:r>
                      <a:endParaRPr lang="pt-BR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100" u="none" strike="noStrike" dirty="0" err="1">
                          <a:effectLst/>
                        </a:rPr>
                        <a:t>Ubc</a:t>
                      </a:r>
                      <a:endParaRPr lang="pt-BR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ubiquitin 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ACACAAAGCCCCTCAATC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CCTCCTTGTCCTGGATCTT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2640904139"/>
                  </a:ext>
                </a:extLst>
              </a:tr>
              <a:tr h="250483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apdh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Glyceraldehyde-3-phosphate dehydrogenase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CTGGAGAAACCTGCCAAGTA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TTGCTGTAGCCGTATTC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3913268552"/>
                  </a:ext>
                </a:extLst>
              </a:tr>
              <a:tr h="250483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gk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>
                          <a:effectLst/>
                        </a:rPr>
                        <a:t>phosphoglycerate kinase 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GCAGATTGTTTGGAATGGTC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GCTCACATGGCTGACTTTA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1927232819"/>
                  </a:ext>
                </a:extLst>
              </a:tr>
              <a:tr h="250483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>
                          <a:effectLst/>
                        </a:rPr>
                        <a:t>Hprt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u="none" strike="noStrike" dirty="0" err="1">
                          <a:effectLst/>
                        </a:rPr>
                        <a:t>Hypoxanthine</a:t>
                      </a:r>
                      <a:r>
                        <a:rPr lang="pt-BR" sz="1000" u="none" strike="noStrike" dirty="0">
                          <a:effectLst/>
                        </a:rPr>
                        <a:t> </a:t>
                      </a:r>
                      <a:r>
                        <a:rPr lang="pt-BR" sz="1000" u="none" strike="noStrike" dirty="0" err="1">
                          <a:effectLst/>
                        </a:rPr>
                        <a:t>phosphoribosyltransferase</a:t>
                      </a:r>
                      <a:r>
                        <a:rPr lang="pt-BR" sz="1000" u="none" strike="noStrike" dirty="0">
                          <a:effectLst/>
                        </a:rPr>
                        <a:t> 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GCTGACCTGCTGGATTACAT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TTGGGGCTGTACTGCTTAAC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1" marR="5881" marT="5881" marB="0" anchor="ctr"/>
                </a:tc>
                <a:extLst>
                  <a:ext uri="{0D108BD9-81ED-4DB2-BD59-A6C34878D82A}">
                    <a16:rowId xmlns:a16="http://schemas.microsoft.com/office/drawing/2014/main" val="29620889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559638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D5EB38B5-953A-F6DC-A625-2B00BFD328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8813914"/>
              </p:ext>
            </p:extLst>
          </p:nvPr>
        </p:nvGraphicFramePr>
        <p:xfrm>
          <a:off x="841951" y="1702953"/>
          <a:ext cx="7464318" cy="664228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4128">
                  <a:extLst>
                    <a:ext uri="{9D8B030D-6E8A-4147-A177-3AD203B41FA5}">
                      <a16:colId xmlns:a16="http://schemas.microsoft.com/office/drawing/2014/main" val="1500553657"/>
                    </a:ext>
                  </a:extLst>
                </a:gridCol>
                <a:gridCol w="1201381">
                  <a:extLst>
                    <a:ext uri="{9D8B030D-6E8A-4147-A177-3AD203B41FA5}">
                      <a16:colId xmlns:a16="http://schemas.microsoft.com/office/drawing/2014/main" val="169483836"/>
                    </a:ext>
                  </a:extLst>
                </a:gridCol>
                <a:gridCol w="2161480">
                  <a:extLst>
                    <a:ext uri="{9D8B030D-6E8A-4147-A177-3AD203B41FA5}">
                      <a16:colId xmlns:a16="http://schemas.microsoft.com/office/drawing/2014/main" val="390102929"/>
                    </a:ext>
                  </a:extLst>
                </a:gridCol>
                <a:gridCol w="846582">
                  <a:extLst>
                    <a:ext uri="{9D8B030D-6E8A-4147-A177-3AD203B41FA5}">
                      <a16:colId xmlns:a16="http://schemas.microsoft.com/office/drawing/2014/main" val="3672754369"/>
                    </a:ext>
                  </a:extLst>
                </a:gridCol>
                <a:gridCol w="2230747">
                  <a:extLst>
                    <a:ext uri="{9D8B030D-6E8A-4147-A177-3AD203B41FA5}">
                      <a16:colId xmlns:a16="http://schemas.microsoft.com/office/drawing/2014/main" val="3332514154"/>
                    </a:ext>
                  </a:extLst>
                </a:gridCol>
              </a:tblGrid>
              <a:tr h="1082801">
                <a:tc>
                  <a:txBody>
                    <a:bodyPr/>
                    <a:lstStyle/>
                    <a:p>
                      <a:pPr algn="l" fontAlgn="b"/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300" b="1" u="none" strike="noStrike" dirty="0">
                          <a:effectLst/>
                        </a:rPr>
                        <a:t># Conserved NFAT Biding Sites</a:t>
                      </a:r>
                      <a:r>
                        <a:rPr lang="en-US" sz="23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er Species</a:t>
                      </a: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7370375"/>
                  </a:ext>
                </a:extLst>
              </a:tr>
              <a:tr h="15164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2300" u="none" strike="noStrike" dirty="0">
                          <a:effectLst/>
                        </a:rPr>
                        <a:t> 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3100" b="1" u="none" strike="noStrike" dirty="0">
                          <a:effectLst/>
                        </a:rPr>
                        <a:t>GENES</a:t>
                      </a:r>
                      <a:endParaRPr lang="en-US" sz="3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300" b="1" u="none" strike="noStrike" dirty="0">
                          <a:effectLst/>
                        </a:rPr>
                        <a:t>Homo X Mus X Chimp X </a:t>
                      </a:r>
                      <a:r>
                        <a:rPr lang="en-US" sz="2300" b="1" u="none" strike="noStrike" dirty="0" err="1">
                          <a:effectLst/>
                        </a:rPr>
                        <a:t>Rhes</a:t>
                      </a:r>
                      <a:r>
                        <a:rPr lang="en-US" sz="2300" b="1" u="none" strike="noStrike" dirty="0">
                          <a:effectLst/>
                        </a:rPr>
                        <a:t> X Rat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300" b="1" u="none" strike="noStrike" dirty="0">
                          <a:effectLst/>
                        </a:rPr>
                        <a:t>Homo X Mus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3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omosome / Promoter Region in Human Genome</a:t>
                      </a: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4771537"/>
                  </a:ext>
                </a:extLst>
              </a:tr>
              <a:tr h="17725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NFAT Responsive </a:t>
                      </a:r>
                    </a:p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Gene (3000pb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vert="vert27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Syn1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2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2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X:47479256-47482256</a:t>
                      </a:r>
                    </a:p>
                  </a:txBody>
                  <a:tcPr marL="12309" marR="12309" marT="12309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6716308"/>
                  </a:ext>
                </a:extLst>
              </a:tr>
              <a:tr h="75681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 NFAT Non- Responsive (6000pb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vert="vert27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 err="1">
                          <a:effectLst/>
                        </a:rPr>
                        <a:t>Xiap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X:122987662-122993662</a:t>
                      </a:r>
                    </a:p>
                  </a:txBody>
                  <a:tcPr marL="12309" marR="12309" marT="1230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1819776"/>
                  </a:ext>
                </a:extLst>
              </a:tr>
              <a:tr h="756818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Pmaip1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18:57561192-57567192</a:t>
                      </a:r>
                    </a:p>
                  </a:txBody>
                  <a:tcPr marL="12309" marR="12309" marT="1230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9215983"/>
                  </a:ext>
                </a:extLst>
              </a:tr>
              <a:tr h="756818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vert="vert27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Map2k4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</a:rPr>
                        <a:t>0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309" marR="12309" marT="12309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17:11918135-11924035</a:t>
                      </a:r>
                    </a:p>
                  </a:txBody>
                  <a:tcPr marL="12309" marR="12309" marT="12309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5075571"/>
                  </a:ext>
                </a:extLst>
              </a:tr>
            </a:tbl>
          </a:graphicData>
        </a:graphic>
      </p:graphicFrame>
      <p:sp>
        <p:nvSpPr>
          <p:cNvPr id="3" name="CaixaDeTexto 2">
            <a:extLst>
              <a:ext uri="{FF2B5EF4-FFF2-40B4-BE49-F238E27FC236}">
                <a16:creationId xmlns:a16="http://schemas.microsoft.com/office/drawing/2014/main" id="{E4D9FF51-A186-90C1-4352-04B45649D663}"/>
              </a:ext>
            </a:extLst>
          </p:cNvPr>
          <p:cNvSpPr txBox="1"/>
          <p:nvPr/>
        </p:nvSpPr>
        <p:spPr>
          <a:xfrm>
            <a:off x="608452" y="8778967"/>
            <a:ext cx="8091712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In order to further analyze the involvement of NFAT regulation in the genes discovered to be responsive to this pathway in qPCR we made a multiple-sequence alignment analysis to detect evolutionarily conserved NFAT transcription factor binding sites. We used Mulan server together with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multiTF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program for comparing multiple finished-quality sequences to identify functional elements conserved over evolutionary time (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Ovcharenko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I Loots GG Genome Res. 2005). We conducted two comparative genome sequence analysis in five mammalian species including, humans, mouse, chimps, rhesus and rat or only in human and mouse. SYN 1 gene has at least two well conserved putative NFAT biding site in their promoter region in all five species (Species: Homo X Mouse X Chimp X Rhesus X Rat and position from the transcription start, respectively:</a:t>
            </a:r>
          </a:p>
          <a:p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1 V$NFAT_Q4_01 + 643-65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31-640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43-65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43-65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625-634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tGGACActt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  <a:p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2 V$NFAT_Q4_01 + 953-96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tGGAGAaa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907-916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aGGAAAct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951-960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tGGAGAaa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955-964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tGGAGAaa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+ 873-882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aGGAAAct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). Consistently, the NFAT non-responsive genes promoters displayed no conserved putative NFAT biding site even when only human and mouse promoter were aligned. We considered promoter region for SYN 1 gene a -3000bp and for non-regulated genes a -6000bp in relation to the transcription start. The larger promoter region considered for NFAT non-regulated regions was to further demonstrate the inexistence of a conserved putative NFAT biding site in these genes. </a:t>
            </a:r>
            <a:endParaRPr lang="pt-BR" sz="1400" dirty="0"/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F4262EB9-549B-8CFE-907E-51CD7027F182}"/>
              </a:ext>
            </a:extLst>
          </p:cNvPr>
          <p:cNvSpPr txBox="1"/>
          <p:nvPr/>
        </p:nvSpPr>
        <p:spPr>
          <a:xfrm>
            <a:off x="255514" y="369651"/>
            <a:ext cx="11286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Table S2:</a:t>
            </a:r>
          </a:p>
        </p:txBody>
      </p:sp>
    </p:spTree>
    <p:extLst>
      <p:ext uri="{BB962C8B-B14F-4D97-AF65-F5344CB8AC3E}">
        <p14:creationId xmlns:p14="http://schemas.microsoft.com/office/powerpoint/2010/main" val="40646717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6</TotalTime>
  <Words>1233</Words>
  <Application>Microsoft Office PowerPoint</Application>
  <PresentationFormat>A3 Paper (297x420 mm)</PresentationFormat>
  <Paragraphs>503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ema do Offic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Bruno Robbs</dc:creator>
  <cp:lastModifiedBy>Jini Mol</cp:lastModifiedBy>
  <cp:revision>3</cp:revision>
  <dcterms:created xsi:type="dcterms:W3CDTF">2022-07-20T14:40:22Z</dcterms:created>
  <dcterms:modified xsi:type="dcterms:W3CDTF">2023-07-21T08:21:16Z</dcterms:modified>
</cp:coreProperties>
</file>